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2" r:id="rId2"/>
    <p:sldId id="302" r:id="rId3"/>
    <p:sldId id="313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24" userDrawn="1">
          <p15:clr>
            <a:srgbClr val="A4A3A4"/>
          </p15:clr>
        </p15:guide>
        <p15:guide id="2" pos="3386" userDrawn="1">
          <p15:clr>
            <a:srgbClr val="A4A3A4"/>
          </p15:clr>
        </p15:guide>
        <p15:guide id="3" pos="3840" userDrawn="1">
          <p15:clr>
            <a:srgbClr val="A4A3A4"/>
          </p15:clr>
        </p15:guide>
        <p15:guide id="4" orient="horz" pos="32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niel Rico Bargues" initials="DRB" lastIdx="1" clrIdx="0">
    <p:extLst>
      <p:ext uri="{19B8F6BF-5375-455C-9EA6-DF929625EA0E}">
        <p15:presenceInfo xmlns:p15="http://schemas.microsoft.com/office/powerpoint/2012/main" userId="S-1-5-21-217838727-779646833-3878702524-27785" providerId="AD"/>
      </p:ext>
    </p:extLst>
  </p:cmAuthor>
  <p:cmAuthor id="2" name="Cristina Martínez Villaluenga" initials="CMV" lastIdx="1" clrIdx="1">
    <p:extLst>
      <p:ext uri="{19B8F6BF-5375-455C-9EA6-DF929625EA0E}">
        <p15:presenceInfo xmlns:p15="http://schemas.microsoft.com/office/powerpoint/2012/main" userId="S-1-5-21-649540239-406398937-3570103097-4726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FF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33398EC-C951-4AC8-BF7E-678ADC764D8A}" v="59" dt="2020-11-22T19:40:58.493"/>
    <p1510:client id="{270B1BA4-9F87-4EF9-905B-DA0AFE67291F}" v="82" dt="2020-11-22T07:56:48.2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998" y="96"/>
      </p:cViewPr>
      <p:guideLst>
        <p:guide orient="horz" pos="2024"/>
        <p:guide pos="3386"/>
        <p:guide pos="3840"/>
        <p:guide orient="horz" pos="32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Rico" userId="0a475d9e3b43bc68" providerId="LiveId" clId="{270B1BA4-9F87-4EF9-905B-DA0AFE67291F}"/>
    <pc:docChg chg="undo custSel addSld delSld modSld sldOrd">
      <pc:chgData name="Daniel Rico" userId="0a475d9e3b43bc68" providerId="LiveId" clId="{270B1BA4-9F87-4EF9-905B-DA0AFE67291F}" dt="2020-11-22T15:16:53.902" v="208" actId="20577"/>
      <pc:docMkLst>
        <pc:docMk/>
      </pc:docMkLst>
      <pc:sldChg chg="modSp mod delCm">
        <pc:chgData name="Daniel Rico" userId="0a475d9e3b43bc68" providerId="LiveId" clId="{270B1BA4-9F87-4EF9-905B-DA0AFE67291F}" dt="2020-11-22T07:13:31.361" v="1" actId="20577"/>
        <pc:sldMkLst>
          <pc:docMk/>
          <pc:sldMk cId="1717539364" sldId="256"/>
        </pc:sldMkLst>
        <pc:spChg chg="mod">
          <ac:chgData name="Daniel Rico" userId="0a475d9e3b43bc68" providerId="LiveId" clId="{270B1BA4-9F87-4EF9-905B-DA0AFE67291F}" dt="2020-11-22T07:13:31.361" v="1" actId="20577"/>
          <ac:spMkLst>
            <pc:docMk/>
            <pc:sldMk cId="1717539364" sldId="256"/>
            <ac:spMk id="13" creationId="{E0E178D0-1489-4419-B8DF-3C654D215D4E}"/>
          </ac:spMkLst>
        </pc:spChg>
      </pc:sldChg>
      <pc:sldChg chg="addSp delSp modSp mod">
        <pc:chgData name="Daniel Rico" userId="0a475d9e3b43bc68" providerId="LiveId" clId="{270B1BA4-9F87-4EF9-905B-DA0AFE67291F}" dt="2020-11-22T15:16:53.902" v="208" actId="20577"/>
        <pc:sldMkLst>
          <pc:docMk/>
          <pc:sldMk cId="2856282390" sldId="290"/>
        </pc:sldMkLst>
        <pc:spChg chg="mod">
          <ac:chgData name="Daniel Rico" userId="0a475d9e3b43bc68" providerId="LiveId" clId="{270B1BA4-9F87-4EF9-905B-DA0AFE67291F}" dt="2020-11-22T15:16:53.902" v="208" actId="20577"/>
          <ac:spMkLst>
            <pc:docMk/>
            <pc:sldMk cId="2856282390" sldId="290"/>
            <ac:spMk id="5" creationId="{421A7CC0-822B-44F2-95B8-BC263886354A}"/>
          </ac:spMkLst>
        </pc:spChg>
        <pc:graphicFrameChg chg="add del mod">
          <ac:chgData name="Daniel Rico" userId="0a475d9e3b43bc68" providerId="LiveId" clId="{270B1BA4-9F87-4EF9-905B-DA0AFE67291F}" dt="2020-11-22T07:55:37.018" v="114" actId="478"/>
          <ac:graphicFrameMkLst>
            <pc:docMk/>
            <pc:sldMk cId="2856282390" sldId="290"/>
            <ac:graphicFrameMk id="4" creationId="{E4E44AF9-4BE5-4741-89C4-32146BBA1622}"/>
          </ac:graphicFrameMkLst>
        </pc:graphicFrameChg>
        <pc:graphicFrameChg chg="mod">
          <ac:chgData name="Daniel Rico" userId="0a475d9e3b43bc68" providerId="LiveId" clId="{270B1BA4-9F87-4EF9-905B-DA0AFE67291F}" dt="2020-11-22T07:56:36.597" v="122"/>
          <ac:graphicFrameMkLst>
            <pc:docMk/>
            <pc:sldMk cId="2856282390" sldId="290"/>
            <ac:graphicFrameMk id="7" creationId="{5FE2AA97-0337-4FFD-92B3-7C106325AAFF}"/>
          </ac:graphicFrameMkLst>
        </pc:graphicFrameChg>
      </pc:sldChg>
      <pc:sldChg chg="modSp mod ord">
        <pc:chgData name="Daniel Rico" userId="0a475d9e3b43bc68" providerId="LiveId" clId="{270B1BA4-9F87-4EF9-905B-DA0AFE67291F}" dt="2020-11-22T15:16:13.558" v="197" actId="20577"/>
        <pc:sldMkLst>
          <pc:docMk/>
          <pc:sldMk cId="3116392245" sldId="297"/>
        </pc:sldMkLst>
        <pc:spChg chg="mod">
          <ac:chgData name="Daniel Rico" userId="0a475d9e3b43bc68" providerId="LiveId" clId="{270B1BA4-9F87-4EF9-905B-DA0AFE67291F}" dt="2020-11-22T15:16:13.558" v="197" actId="20577"/>
          <ac:spMkLst>
            <pc:docMk/>
            <pc:sldMk cId="3116392245" sldId="297"/>
            <ac:spMk id="12" creationId="{C36FF3F3-EF19-412C-BC4E-4FCBF1928AED}"/>
          </ac:spMkLst>
        </pc:spChg>
      </pc:sldChg>
      <pc:sldChg chg="modSp mod ord">
        <pc:chgData name="Daniel Rico" userId="0a475d9e3b43bc68" providerId="LiveId" clId="{270B1BA4-9F87-4EF9-905B-DA0AFE67291F}" dt="2020-11-22T15:16:23.042" v="200" actId="20577"/>
        <pc:sldMkLst>
          <pc:docMk/>
          <pc:sldMk cId="2571561803" sldId="298"/>
        </pc:sldMkLst>
        <pc:spChg chg="mod">
          <ac:chgData name="Daniel Rico" userId="0a475d9e3b43bc68" providerId="LiveId" clId="{270B1BA4-9F87-4EF9-905B-DA0AFE67291F}" dt="2020-11-22T15:16:23.042" v="200" actId="20577"/>
          <ac:spMkLst>
            <pc:docMk/>
            <pc:sldMk cId="2571561803" sldId="298"/>
            <ac:spMk id="45" creationId="{979E2B8D-774D-4883-93BC-08956FBBC8CC}"/>
          </ac:spMkLst>
        </pc:spChg>
        <pc:graphicFrameChg chg="mod">
          <ac:chgData name="Daniel Rico" userId="0a475d9e3b43bc68" providerId="LiveId" clId="{270B1BA4-9F87-4EF9-905B-DA0AFE67291F}" dt="2020-11-22T07:17:24.096" v="23" actId="20577"/>
          <ac:graphicFrameMkLst>
            <pc:docMk/>
            <pc:sldMk cId="2571561803" sldId="298"/>
            <ac:graphicFrameMk id="10" creationId="{177E5127-34E3-4582-BF0F-E9B1A6151791}"/>
          </ac:graphicFrameMkLst>
        </pc:graphicFrameChg>
      </pc:sldChg>
      <pc:sldChg chg="modSp mod ord">
        <pc:chgData name="Daniel Rico" userId="0a475d9e3b43bc68" providerId="LiveId" clId="{270B1BA4-9F87-4EF9-905B-DA0AFE67291F}" dt="2020-11-22T15:16:32.495" v="203" actId="20577"/>
        <pc:sldMkLst>
          <pc:docMk/>
          <pc:sldMk cId="1949403244" sldId="300"/>
        </pc:sldMkLst>
        <pc:spChg chg="mod">
          <ac:chgData name="Daniel Rico" userId="0a475d9e3b43bc68" providerId="LiveId" clId="{270B1BA4-9F87-4EF9-905B-DA0AFE67291F}" dt="2020-11-22T15:16:32.495" v="203" actId="20577"/>
          <ac:spMkLst>
            <pc:docMk/>
            <pc:sldMk cId="1949403244" sldId="300"/>
            <ac:spMk id="3" creationId="{F09DCA62-E122-4A69-87C8-CF4878B78657}"/>
          </ac:spMkLst>
        </pc:spChg>
      </pc:sldChg>
      <pc:sldChg chg="modSp mod">
        <pc:chgData name="Daniel Rico" userId="0a475d9e3b43bc68" providerId="LiveId" clId="{270B1BA4-9F87-4EF9-905B-DA0AFE67291F}" dt="2020-11-22T15:15:52.808" v="193" actId="20577"/>
        <pc:sldMkLst>
          <pc:docMk/>
          <pc:sldMk cId="2711957844" sldId="303"/>
        </pc:sldMkLst>
        <pc:spChg chg="mod">
          <ac:chgData name="Daniel Rico" userId="0a475d9e3b43bc68" providerId="LiveId" clId="{270B1BA4-9F87-4EF9-905B-DA0AFE67291F}" dt="2020-11-22T15:15:52.808" v="193" actId="20577"/>
          <ac:spMkLst>
            <pc:docMk/>
            <pc:sldMk cId="2711957844" sldId="303"/>
            <ac:spMk id="4" creationId="{30602BBA-EFEA-4BA9-A5B8-6E13F77F3784}"/>
          </ac:spMkLst>
        </pc:spChg>
      </pc:sldChg>
      <pc:sldChg chg="modSp mod">
        <pc:chgData name="Daniel Rico" userId="0a475d9e3b43bc68" providerId="LiveId" clId="{270B1BA4-9F87-4EF9-905B-DA0AFE67291F}" dt="2020-11-22T15:16:49.433" v="207" actId="20577"/>
        <pc:sldMkLst>
          <pc:docMk/>
          <pc:sldMk cId="558716251" sldId="304"/>
        </pc:sldMkLst>
        <pc:spChg chg="mod">
          <ac:chgData name="Daniel Rico" userId="0a475d9e3b43bc68" providerId="LiveId" clId="{270B1BA4-9F87-4EF9-905B-DA0AFE67291F}" dt="2020-11-22T15:16:49.433" v="207" actId="20577"/>
          <ac:spMkLst>
            <pc:docMk/>
            <pc:sldMk cId="558716251" sldId="304"/>
            <ac:spMk id="5" creationId="{9C1F7266-8B41-43E4-B13D-C300C95615DA}"/>
          </ac:spMkLst>
        </pc:spChg>
      </pc:sldChg>
      <pc:sldChg chg="addSp delSp modSp mod ord">
        <pc:chgData name="Daniel Rico" userId="0a475d9e3b43bc68" providerId="LiveId" clId="{270B1BA4-9F87-4EF9-905B-DA0AFE67291F}" dt="2020-11-22T15:16:41.839" v="206" actId="20577"/>
        <pc:sldMkLst>
          <pc:docMk/>
          <pc:sldMk cId="3010957323" sldId="306"/>
        </pc:sldMkLst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" creationId="{9E1A6288-3FA2-4B41-8F62-2889EF79896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" creationId="{2621F72D-FBA2-4669-B530-8C0FE89368CE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6" creationId="{EF7ABD86-6F4B-4E7A-B8BC-E56EBBEDAC0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8" creationId="{240483B6-B15A-415B-9FD5-66B0EEFA0C2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9" creationId="{6CD314C8-06C4-4E6B-8C41-FFF460CE540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0" creationId="{EC1C7803-5670-4900-87AB-A59F2A22B9C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1" creationId="{A0E76365-D930-40A1-A226-F345FC2C365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2" creationId="{8421AC01-55CF-41E8-8D71-D86CABD2C2B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3" creationId="{ABD7B9F8-53A2-41CB-8BD1-C6259FE588D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4" creationId="{8C053100-CAF0-4848-A20F-19A2C2977B7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5" creationId="{047C1FD2-F62C-40D3-9928-E68FEA6302C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6" creationId="{E91A3D5D-DBC5-4439-972F-A132BCBEEF2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7" creationId="{3AF91D3F-7FC3-4F8E-A048-A4EB9BB5EC9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8" creationId="{3026913C-1810-4EC2-A7C4-D395F57B627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19" creationId="{B35938A1-DB70-4A41-96C2-16C51329EEB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20" creationId="{EA16DF27-ACA1-4B2C-9081-6CFCB334F364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1" creationId="{1B55FEF8-50BE-4FA2-9694-B73444E3B21F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2" creationId="{A74E5D42-F771-4D84-ADF4-A088DA6459A3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3" creationId="{CDC12024-ED5C-43C8-8AEB-26C98C37E378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4" creationId="{9069E4B6-1F59-45D7-A2A1-76546174A3C5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5" creationId="{6846DCE1-439F-4F29-9178-9259542DA37D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6" creationId="{11BC9522-8CAD-4E0F-AF2B-080EE627C9DE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7" creationId="{9A7D622F-A6BB-4D54-AF7E-02404C00C0F3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8" creationId="{4BD10E3C-8F49-4A45-863A-381D17C225A7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29" creationId="{09E11B72-EC4C-41F0-8A68-CBD0C70E1FA4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30" creationId="{441FAB20-9DE7-477F-8AD4-FB5BE302C07D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31" creationId="{8E00C3B1-58F5-427A-9EF5-7DAA08D4D6AD}"/>
          </ac:spMkLst>
        </pc:spChg>
        <pc:spChg chg="add del mod topLvl">
          <ac:chgData name="Daniel Rico" userId="0a475d9e3b43bc68" providerId="LiveId" clId="{270B1BA4-9F87-4EF9-905B-DA0AFE67291F}" dt="2020-11-22T07:54:06.251" v="99" actId="164"/>
          <ac:spMkLst>
            <pc:docMk/>
            <pc:sldMk cId="3010957323" sldId="306"/>
            <ac:spMk id="32" creationId="{21A26821-5028-4045-9982-7D0618EDF5C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3" creationId="{A5AA61DC-B2DA-4545-9993-9C48A341E4F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4" creationId="{46C2FDCA-882E-4011-8D06-9333AD73591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5" creationId="{81E0675D-3304-4634-A3E4-EBCE114272A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6" creationId="{4ED64135-9CB5-40D3-964B-D833586E61F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7" creationId="{3DAFD665-8C57-4DA8-AA38-10835BB693E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8" creationId="{C7FDB139-0612-491F-B791-884F1DF02A5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39" creationId="{F9CD166A-4672-4D7A-9342-EAED1D0752D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0" creationId="{E34AFF59-5BB8-49EC-A25E-6EBAE66A035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1" creationId="{C47AAF41-65BE-4A8B-85B0-41321084373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2" creationId="{6D43ED54-04FD-42E4-AFC4-092B40997B4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3" creationId="{C3D91069-2DA7-45AA-8855-398D1D58C69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4" creationId="{D23B4D72-CC35-46B7-8C5F-ABF165DBAEC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5" creationId="{2A6DB4F0-6656-4D62-B3DE-BED58B63E38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6" creationId="{060E063A-C4E8-4737-BFC2-FAF30312334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7" creationId="{DC4252AC-65C4-4305-B856-198E7BBB8D7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8" creationId="{9788B7D7-BD37-4025-A7CA-C6E332ABC1C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49" creationId="{A43E708F-963E-4A4D-B928-287B2BA506A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0" creationId="{8C8DB565-D89E-4CF3-91A1-F83A64EA7F9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" creationId="{18C145AF-9931-4DDD-9A06-2BE0B9B951C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" creationId="{E11173E3-B27C-4805-89C4-4BF1902055F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" creationId="{72BD3D68-E612-486A-8206-99945ADC096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" creationId="{A59A5E5C-2EEB-4D86-A9A4-4A05291FD49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" creationId="{58962A8C-EA0A-4A71-BBAB-4EDE5A94D1C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" creationId="{6468C49A-0338-42A7-8C4E-65C48A4D6AA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" creationId="{1EFC33EB-FA4B-4D88-BBDB-61BD81AC405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" creationId="{C1823F7F-F95E-4FCB-8067-DCA818D03AF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" creationId="{269F5F80-C9E7-4868-A1DC-970D37B70C1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" creationId="{C91406B8-84AC-479F-BF78-73A092A0A13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" creationId="{21C5BC77-BCB6-4BFA-81D6-73F5F8ACFF9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" creationId="{6E72E97A-300D-4894-8BA6-B232BB476FC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" creationId="{21814721-9AE9-4809-9DDC-486424BF536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2" creationId="{2824CA0D-789B-4C03-8351-DF309CC0078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3" creationId="{F7D86714-2D7C-4AB8-9C35-5D69EB92EF1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4" creationId="{E1846FBC-0113-4D54-9EDD-5DD56F6C369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5" creationId="{9D891F81-2034-41D9-A0AB-A65682AD520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6" creationId="{561165EE-C701-44B6-B168-5C56B735988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7" creationId="{9514F94E-6C00-4DF7-A841-E8DDD77AC5B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8" creationId="{EA523DD4-2F0B-4348-BDE3-0A86E7EF23D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19" creationId="{46864B9C-D41C-45C9-843B-073E72C20BA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0" creationId="{1445B80F-F47C-4D19-B3CF-CF425596E61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1" creationId="{06FE0375-EDF6-4BC8-896A-7127CD8E1FD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2" creationId="{9C10DB3B-7369-4E3C-A6F8-F33100CACF8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3" creationId="{B176FE80-20DB-47BA-9301-052F60E0BFB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4" creationId="{EDF9EF34-CE9C-49FD-8125-703176381DD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5" creationId="{21393594-DDD5-4065-9421-0F06DA89C40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6" creationId="{98DD5160-2524-4A3A-BC35-78D1796A1EC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7" creationId="{E7A9F238-0762-44CA-8ECA-C84AA834FC3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8" creationId="{B31EC0F2-6EC2-4F49-A1BF-BFC3F939684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29" creationId="{2018A44F-E19A-4E51-BEFC-47BE469EEF7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0" creationId="{6DDA2A55-40D1-4F17-85B9-190B7F19A5D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1" creationId="{AF52A9B5-8042-4B35-A817-2642684C9CC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2" creationId="{5E22050F-830F-4ABA-BF92-51A915AE4F17}"/>
          </ac:spMkLst>
        </pc:spChg>
        <pc:spChg chg="mod">
          <ac:chgData name="Daniel Rico" userId="0a475d9e3b43bc68" providerId="LiveId" clId="{270B1BA4-9F87-4EF9-905B-DA0AFE67291F}" dt="2020-11-22T15:16:41.839" v="206" actId="20577"/>
          <ac:spMkLst>
            <pc:docMk/>
            <pc:sldMk cId="3010957323" sldId="306"/>
            <ac:spMk id="533" creationId="{B7CA3355-618D-4360-B015-801313E7F1E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4" creationId="{60768DFB-6E2C-40F4-9D70-FC183F4CC78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5" creationId="{DE703961-308B-479B-A20D-78578AEA6B7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6" creationId="{71DC6437-F9DB-4472-AE61-3DC5CB41099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7" creationId="{8C597846-40BC-44DF-AB3E-9F17F185BF5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8" creationId="{5F949F6E-623E-4E8A-9BB7-49C51CEA5FE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39" creationId="{2C17AD43-CE16-40CC-A7FC-78AD5E11DAC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0" creationId="{DD718B04-0E1E-4589-B7E0-75D28FD7ABF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1" creationId="{72C2CE69-A13D-49D1-968B-32FFCCF6593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2" creationId="{A1B499B6-B415-4557-AF5B-68367308EC5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3" creationId="{BCCDAC23-24B4-427F-831D-DB308735AB8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4" creationId="{2926BF06-B91A-48AF-92FF-033AF6BC262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5" creationId="{7D09786E-7981-4882-BAC8-1196C62BC7A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6" creationId="{0A48504F-3C58-4E7B-869E-37DB887B245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7" creationId="{C32407D2-BE7C-4396-938C-E5A5AA5B882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8" creationId="{997214F6-968D-4CA3-A2CE-676D330D145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49" creationId="{7AEDA643-6131-401D-8265-78C4C1C8F00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0" creationId="{01D1CA08-7FF9-4E2A-AA08-2CEB0D20F40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1" creationId="{B9593029-D63C-4159-A3B9-FAC81859B0F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2" creationId="{2730EF6B-712A-40B0-B359-907BA82F65B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3" creationId="{DC8C0DE4-C7F9-4F45-ACCE-3B221824091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4" creationId="{6143BE13-646E-4B38-838B-3AAE0DA629C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5" creationId="{FE2CAE2F-729D-4FC7-A76A-B8CE7FBD9C2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6" creationId="{3EC94923-13CF-4B9E-97CE-2B2E8196E36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7" creationId="{F1940749-A8DF-42FF-BD33-3F2B14C771D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8" creationId="{259EC4AB-0640-47B2-B49F-DF2FF70E45D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59" creationId="{78D26CA7-FD1C-4BCA-AD71-98B498BF168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0" creationId="{941F6752-E11E-43E9-A050-7F3571CB1A0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1" creationId="{F3A3ADB9-C359-4EF4-8DA1-F0A11B09100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2" creationId="{EFF45CE2-5335-4884-A861-7A3FA205BFD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3" creationId="{A6FC398A-B0C0-4022-9CA9-F69D5D82BD7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4" creationId="{B48EAB37-1884-46A5-B846-15BEFBD0EAA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5" creationId="{6A4DE07B-BAA5-4899-A035-71E5D737FA6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6" creationId="{524E0EB5-2D86-4C35-A133-5C540E259D0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7" creationId="{AB0E3C46-A421-4707-9340-7A979435938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8" creationId="{84F2518E-3EE9-4E11-A6E6-EE13F5945E8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69" creationId="{0958809E-D3D1-4D5A-8A42-9B214F0AD99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0" creationId="{3725B0A2-6AE4-4C83-A824-508953D379C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1" creationId="{5B97B3E1-1072-47D3-9A0D-75DB58A3251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2" creationId="{88986F50-8DB0-4A8A-99DC-3724ADF3BDD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3" creationId="{0462ADD5-D8DF-4808-AF0C-34A5C7391A7C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4" creationId="{34153439-9133-43A1-B079-8957D21D3F8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5" creationId="{B6DB085A-0908-45A7-83D6-478936EE263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6" creationId="{1F305AFB-C076-40DA-922F-A7C8DE73E3A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7" creationId="{754A1493-CFDE-4AF6-A887-42A9EDFABD4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8" creationId="{C19A89D2-4D29-4BCE-978C-BA375E98781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79" creationId="{9DB8004E-6F34-4592-A44E-6FAC3BC98A1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0" creationId="{B2989F6D-D5E6-42CA-BEC1-E5E975B6D47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1" creationId="{2A4218A8-B65E-4668-9699-0C910B5C6B5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2" creationId="{CAAC8ACD-2FFA-4C68-9CF2-9E0602A24CD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3" creationId="{72162E5A-8753-47EF-8FF5-F9BC407A12A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4" creationId="{1CCF5F90-B304-4F9D-BB76-98D78FD0077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5" creationId="{F6AAFF6C-35A4-4F28-B8AD-93594CF3EBC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6" creationId="{254D4C25-3887-449A-8B44-D8A5C08E9E7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7" creationId="{30D129FC-AC02-4E54-ABA8-DE5EEBD91C8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8" creationId="{30658DDE-41EE-4138-AD8D-56E9A4101A4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89" creationId="{CDCD46B9-0F41-432A-A8BD-9CB82B12A05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0" creationId="{ECBA7B40-0E38-43F5-AE93-41C9E53093D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1" creationId="{B1A8FEB0-C875-4EDC-BF2A-8AADBFAEAD9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2" creationId="{CD70B3B8-A9C0-44D2-9954-96BE71B2FBE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3" creationId="{DB6BA897-C546-4304-ACEE-BF150836747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4" creationId="{4B0A105A-A529-42F0-A2A3-2D7A36B3F91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5" creationId="{E897C943-C3F3-41F7-842C-198A61BC788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6" creationId="{B98DDD5D-A708-4F90-AEA2-4E3651A6EBB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7" creationId="{C6ACD3E7-9897-47A2-9440-D21E71917B0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8" creationId="{8EEEE1C2-549D-4A96-B284-4FF6F1442CD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599" creationId="{D327A81D-F1A0-4BF9-9446-C751ED0B9F3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0" creationId="{11033A06-0FF1-4D2C-B2A9-FF3A03982B0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1" creationId="{3586EA71-FBAD-4EA7-BEF1-A7AE77689AC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2" creationId="{21FC12B1-1F76-4064-AC6B-E03FBC9C746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3" creationId="{F9DD1D78-3601-4BEA-AA86-43546E13237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4" creationId="{99377D37-8FD9-4AB3-8385-BAB4FD6D730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5" creationId="{4ADF37A2-C22D-4855-8D20-EFD8D713CCA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6" creationId="{99D063FB-DAB7-47D9-85F1-AE89D7F8B1E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7" creationId="{8C603C53-771D-4A23-97BF-46470AF5626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8" creationId="{17BACBB4-EAD3-4776-B114-31C9F8DE665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09" creationId="{6DF39507-ED15-4CDF-8128-7EF51B0BC68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0" creationId="{18A63779-02B8-4118-9DAC-0FA9D855C22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1" creationId="{968AB78A-FE5B-42C8-B1A0-13548A612A5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2" creationId="{E1C2CC37-9F4F-4371-807D-935B79467F1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3" creationId="{23C30E53-4F79-4D4C-8528-4165B3D472C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4" creationId="{A75994D3-F60C-451E-904A-34C14AFAC2E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5" creationId="{969ED897-1C2B-44B7-9F6A-8115AFD6F3B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6" creationId="{F2696FB3-B7B4-49A3-95D8-DF6C3E215B3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7" creationId="{95852D82-0909-4060-812F-BFE6501C003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8" creationId="{A0B31CA6-30AC-49DC-BFF4-4CCBED471D2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19" creationId="{BB9975D0-6A71-4214-8AAF-73276BDC914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0" creationId="{364E7CA6-1A32-4B41-99BC-94F654A4967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1" creationId="{DDA12C1E-CC25-48A5-BAFF-DA6BE2DDD7B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2" creationId="{1BFC5EAE-39C4-4117-8BAF-C7B161F3587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3" creationId="{F92B84CC-AABD-4980-A889-D69F69093FF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4" creationId="{5EE14CF9-6432-4B65-A871-89D17E8F5FB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5" creationId="{53B204E5-A75D-4ABF-9743-D70BFB8A883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6" creationId="{943CE5D8-C4F1-4426-A67D-17EA1F64766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7" creationId="{1165B6C0-B178-4780-A2AB-DF337268100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8" creationId="{8F047CB6-F378-461A-BCEE-7DE78C07011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29" creationId="{57084B83-C241-4186-85FD-54A39264BFC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0" creationId="{90AF3358-2B58-4499-A1F3-AF1707C0C5C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1" creationId="{F6EFB205-F85A-4775-8C3B-D87289F908D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2" creationId="{E60B18BC-F0E1-4793-8B43-AD969A70C2D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3" creationId="{63D0BCA9-9828-4FB3-B4B1-8DB37C71BFC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4" creationId="{34ADDB69-9701-4AA1-A138-58D3A0F6225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5" creationId="{FD80FC9D-B929-4963-B3B6-12FE583DDC9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6" creationId="{48716561-BA3A-4B8C-B27B-D5335088F7F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7" creationId="{09CA1F74-AA4B-4230-ADF0-0A6E4C89E2E4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8" creationId="{76FBB494-03C0-4858-80C8-898E99799A7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39" creationId="{62FA8544-2314-496A-9920-FE4CD6D1A78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0" creationId="{A3AB64EF-FCA3-46D4-BEF0-0B90FF44AC2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1" creationId="{2D5D888E-693C-4993-A3A8-E88872344640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2" creationId="{4324A573-4C25-4416-8C5B-1A82FFAE16A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3" creationId="{61C3FE06-1DD2-4730-884B-6D956B7815BA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4" creationId="{34CD283E-D371-4631-A933-77E58C4DDF57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5" creationId="{46D9EC3F-8E88-46F7-94B8-161BE0689E02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6" creationId="{D163BBD8-2097-451A-9882-A9027E5F8CAE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7" creationId="{6BA52748-724E-4ECD-801F-09D0F52C7C6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8" creationId="{B73C0BF6-F0DC-4C1D-9B08-4B025BA8DAE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49" creationId="{1BD07A07-AE06-4D18-AF45-8541CD76E763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0" creationId="{2358562C-A9D5-479E-9FD8-58BBEF68A0E1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1" creationId="{5727739F-8BC0-4125-A50A-E21E318B4F9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2" creationId="{C4DAEF81-CA60-45CB-B086-C91A9F77975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3" creationId="{BB91A07A-7A22-4D05-B98F-FEBDA0CEFBFB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4" creationId="{22E6DD0A-08F1-489F-8241-0E18B7687BF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5" creationId="{E4763CAB-B623-4219-B390-F1C2E7D11BD6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6" creationId="{B99891D5-AE17-45E5-8302-BD0E416F40B8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7" creationId="{08E19644-0668-4157-9DFC-3BEA1450E79F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8" creationId="{9C2645DF-3FEC-4B53-94E3-47CA86BE4159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59" creationId="{9912C6AB-8366-440F-9627-ED3E97F54445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60" creationId="{4BB639B1-47C1-40AC-8B37-F4B9C7994F8D}"/>
          </ac:spMkLst>
        </pc:spChg>
        <pc:spChg chg="mod">
          <ac:chgData name="Daniel Rico" userId="0a475d9e3b43bc68" providerId="LiveId" clId="{270B1BA4-9F87-4EF9-905B-DA0AFE67291F}" dt="2020-11-22T07:18:20.162" v="26" actId="338"/>
          <ac:spMkLst>
            <pc:docMk/>
            <pc:sldMk cId="3010957323" sldId="306"/>
            <ac:spMk id="661" creationId="{5730FEE6-0689-45C3-8DA1-D0636B87F02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3" creationId="{9A7C7C83-56AF-4E01-9F4B-B8E7CB34C35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4" creationId="{8FE71504-647F-4CA2-ACD2-B88DEBDD78E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5" creationId="{26849440-29FC-4312-A5C4-CAE5D51CE0B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6" creationId="{4F9EBB52-5EC9-4A74-B462-A5FE900E960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7" creationId="{5619F5F2-4A05-4B76-ACC5-79A0A980D35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8" creationId="{78C339C3-D839-4F6F-A5BE-C3BA85D07FB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69" creationId="{B9AADBA0-1F1B-4FD5-A857-16D20024A41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0" creationId="{0F65286F-3732-4F55-A9C8-DD054D20AEF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1" creationId="{DCAF9226-1A51-44AD-8CD6-55A0364DA6B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2" creationId="{875A7320-9BDF-49EB-BB68-B059B1C7CD9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3" creationId="{6174BED8-9FA0-4A56-8035-4E0A9FC48CD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4" creationId="{60E3243A-CDF4-4BBE-81A4-C936CC1C0D7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5" creationId="{94E633F5-94F6-49EA-B913-A0B23D3FB9D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6" creationId="{EB4F47F0-93C5-472D-9E26-03D4D7AFB4D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7" creationId="{153BC5F1-6610-4D87-B08D-48520E79D2A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8" creationId="{A5FAC444-B1C4-4C86-A566-9742DC19998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79" creationId="{87DF09E0-C68F-402A-A609-9A566138C3C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0" creationId="{2E438BFB-00E3-451E-991A-10FCBB1C407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1" creationId="{651895CD-B04B-4D37-B953-60619747E25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2" creationId="{B0049720-0C28-4A20-AEE1-C0CA5CC738E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3" creationId="{C7753714-D517-4E02-A006-A4354FFE4C2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4" creationId="{EE210B95-A249-48EC-A5FA-DFC601CE64E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5" creationId="{7EB3E17A-DCB7-4460-ABA6-1F638166895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6" creationId="{1FDC58FA-B22C-4DE4-9D3F-07F89502262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7" creationId="{1D819D00-EC75-43A5-A528-B91211CF8F8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8" creationId="{CF73906A-7A20-4ADF-82DA-72D6F01CE15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89" creationId="{24A4B54F-98BA-4597-9037-B2B3FB3B512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0" creationId="{E8210DF5-9BEB-46DB-89F8-1894DA21C49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1" creationId="{5D9B9D54-970B-4271-8C75-85007F401C8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2" creationId="{F0D632BE-5C5D-4730-8112-B92C8691C02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3" creationId="{177624D5-E0C7-4E7F-955B-9CC9ECA06C8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4" creationId="{2C69A465-3C94-4485-8A2A-44D45AF399F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5" creationId="{7E2F4353-B722-46C6-94C0-C9CA44D7AD6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6" creationId="{652E516D-7803-40E9-99D7-338281C23CD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7" creationId="{2EC30272-37D9-47E5-B64B-2BD867C7423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8" creationId="{DA0D487F-6502-4F5D-901C-E29ACCEAC0A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699" creationId="{5CE89844-77F0-4D38-9830-03D44EDCF23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0" creationId="{8BFFEB28-8EB3-4287-BA42-AB2C1AA6C2C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1" creationId="{42C4974C-81C3-4545-8008-42C431E72BC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2" creationId="{C51C2152-83BF-484D-A4C3-FFEF81F0A1A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3" creationId="{94F19C0A-C155-4F37-B71A-A7CD5B0F3A2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4" creationId="{E9CB8302-85CD-4238-BECD-2ECEB090ED5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5" creationId="{D22CF42C-3726-4D8E-A771-BF9D7B1366F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6" creationId="{4D965239-CA76-4859-B370-1E8B020931C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7" creationId="{1CCCAE50-AB83-4CDD-BF74-A84E4924E18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8" creationId="{EF6B5DC7-E250-4EAF-90A9-0522B3E1506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09" creationId="{5A9BA33F-9487-442B-A5A1-5E3B9EFF701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0" creationId="{E16724C6-B1A5-4CAF-A711-DE66C5DA12F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1" creationId="{01733BBB-D6E8-47EA-B96F-A46295A8978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2" creationId="{00E9C049-8360-4BC6-BBAE-4D30589D1B6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3" creationId="{51AAFE36-30C8-4B05-B3C0-52E9B4670BA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4" creationId="{DB0A68B0-1711-4E61-B72F-D0CCCFBF916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5" creationId="{F0077837-8A89-48FA-9D23-5B2B4D4E2C5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6" creationId="{A8E2938F-2513-4D57-9F33-F8E7DE110F33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7" creationId="{8999593F-6EA7-4271-8C99-48CBE3995C3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8" creationId="{7417A9D0-7C40-48C3-8421-140B23D320B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19" creationId="{4EDF76F5-DE50-41B2-B268-C2E1FFC9A00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0" creationId="{48F53A4C-EC70-47AB-97D9-D9DC1801265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1" creationId="{CBDAC5EF-7D5D-4325-904F-A6AC8C3C799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2" creationId="{4749D2EE-CB17-4AFF-9F6F-E1E33A5C5CE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3" creationId="{7AD9DF49-699F-46C4-B329-D6EC5BEF559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4" creationId="{E4D0B433-4921-4F00-8A20-A0F5FAFB89D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5" creationId="{6DE65C16-5326-41CC-BCA9-AF3E442DAC2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6" creationId="{A52B4466-FBBB-4C26-9BE5-39689B8B694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7" creationId="{562EB78A-E553-4BD8-86BE-71BCA63DE29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8" creationId="{D73B5D0F-B7D7-48A5-B330-DB1F8B23EBB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29" creationId="{AFC9F846-45B3-45A2-8F0A-95C4C508A85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0" creationId="{A5717322-A574-4312-8DD8-778B8D33017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1" creationId="{D2D7AD11-146B-4C16-8556-659E9E4987A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2" creationId="{B711010C-E0D6-41C8-8B66-F43C6791803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3" creationId="{B5BDADF9-3F65-4D13-837C-A154A5E6C11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4" creationId="{09268FC0-FEAB-422E-8D03-0647C01DA82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5" creationId="{76281CEC-D44A-4CED-9987-190F8B3C915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6" creationId="{FFB17C0D-D159-49F8-A3B1-65EEBBE09E3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7" creationId="{959C5D6B-A792-43EB-806A-047DCAF4F36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8" creationId="{AA5D5860-760E-424A-9944-B590CB541B5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39" creationId="{78D2C3A4-F02F-4360-81A7-820F20A2C1C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0" creationId="{1A2CE436-C289-4E6A-8242-FC43BC1220D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1" creationId="{B86C3FFB-811A-4141-BC29-D1D129FC3E9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2" creationId="{DFE5BF88-3D58-4A60-BBB5-2F096B07A82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3" creationId="{BA9F2F68-59B3-44A6-B3A2-B915F7BFE0B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4" creationId="{BC99ABBC-1580-4A78-989A-4F4883CB6FB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5" creationId="{70CCA4E9-64EA-4ADF-902B-28E07DC6B39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6" creationId="{4D6DF891-C3A7-45D7-BEBB-BFDC631809B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7" creationId="{FA921DCD-38AB-4B41-9C90-EDB7D8B0731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8" creationId="{3F9DABA3-A9D1-4631-9461-92CAAB0E3AC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49" creationId="{F1AF355E-1376-469F-9E54-2B7204F168C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0" creationId="{9DD8686E-8D49-419B-915E-495CB3B069B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1" creationId="{4DCDDA2D-C846-4347-BAF9-EF166B85E6A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2" creationId="{ACFB0DAC-6899-4B1A-A222-098E706BFE4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3" creationId="{B4898FE4-0A55-4982-88B9-EE80A7F5003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4" creationId="{C05B93F2-DDA6-4600-BA4E-7E9BCB81AFC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5" creationId="{DE474039-A246-44B8-B4EE-DE781C8073A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6" creationId="{2016E742-63CE-4BDE-8F9F-E73487DDFB1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7" creationId="{5A40D965-4B61-4F33-B02B-54271570414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8" creationId="{FC2E643E-7B8E-46BF-86EE-9877753B39D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59" creationId="{4523B6B0-03D1-4421-B0C1-F8972FFBEDC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0" creationId="{B301FE9D-178D-4663-8FF5-2620E1E73593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1" creationId="{B840A7AC-2489-49E6-85E1-3518D79BD36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2" creationId="{A97FBD13-EB7B-4487-BAB2-B6BF2750498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3" creationId="{C3FDF831-56B8-44C2-9E2A-8509C70651A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4" creationId="{19A49152-1E85-4888-BBD0-F2B222F7F50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5" creationId="{764B1E34-04F3-4893-A700-5B15B664C01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6" creationId="{008F923C-9E27-43BC-A453-A11429DB763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7" creationId="{88BD0B94-D9B1-471D-8256-F9295829949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8" creationId="{3EF970E7-0FA5-4932-B2AE-5B58FD1895D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69" creationId="{3983B13A-B6CB-46FA-9A02-6DB4330F069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0" creationId="{5D33CD0E-972C-4E4C-A076-A4AA5223C79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1" creationId="{EE9BE32D-DFBE-48D9-A451-943923BCAC8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2" creationId="{3E0E672B-1BBC-49A5-87D6-C057BBF618F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3" creationId="{8D71B3E6-6FFD-4A36-B0A1-A131AEA29AB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4" creationId="{1DA66968-6062-4DE3-AF66-997A7906D8D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5" creationId="{07D2F320-5DED-4655-AF40-DAC29F07586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6" creationId="{EFF956B8-1FA9-49EE-B7D8-27B86C040F2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7" creationId="{6EBEC1CE-3C41-43FF-9908-E09A64CA0D4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8" creationId="{AFC1963B-4BA5-4458-A7EE-89A75DA9743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79" creationId="{96CBE7F3-B6D0-47D4-90A0-212F3797E89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0" creationId="{8146C1BD-98C2-43EB-804E-EE04229405D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1" creationId="{0980B130-1AF8-47C7-A191-FC9F1170652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2" creationId="{4CE0187F-8071-4FF5-86F9-8C2F0D805D93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3" creationId="{AA3648F6-EB88-478B-ACF3-A50398E87A7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4" creationId="{774D1AC5-F472-4C59-AF9E-472AA2B5108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5" creationId="{78CEAF8F-91E6-447C-B5D7-782850A3375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6" creationId="{E4430525-693F-4D5F-B677-1292EC765EC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7" creationId="{22ECB015-A4FD-43CF-A0CA-458FA170FBB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8" creationId="{0E7E4F92-44B5-4D41-85ED-991EC854234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89" creationId="{0BCEDA2E-26AF-4C36-9762-8D5AFAA063A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0" creationId="{7157656C-8AFB-4D14-9F9B-6C45E566187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1" creationId="{783AC006-227E-4DE2-904E-71147CB61A9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2" creationId="{054703D5-4E80-44B7-8FA1-2DCF48231C3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3" creationId="{1FC5EAB3-098C-484F-8AAB-A96DE066EDC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4" creationId="{801B0B77-AC13-49EA-8944-31C2838498A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5" creationId="{15C4A5DD-F092-4F11-8C5F-79B4D46263F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6" creationId="{ED0F7F62-6550-4BE4-96D9-6ADB823F23A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7" creationId="{A31E67EE-49A8-497A-96F8-B244DE435F7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8" creationId="{A96C45ED-F6C6-4E5C-920C-768A8649B5E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799" creationId="{4E189818-5607-4906-8D60-4AAD40E3066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0" creationId="{30EB12B5-D591-42AD-AD3A-C46E013CB44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1" creationId="{75FD94C6-3C71-4396-AAAF-EEB72E76114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2" creationId="{E044102E-ECB7-4101-B722-271CAF4DB5E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3" creationId="{089F91FF-854E-431B-862E-6F1C21FB370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4" creationId="{9709AC1E-DA16-403A-8393-2703282B7B2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5" creationId="{9C905ADC-9D17-4771-9395-AF06FA21BB9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6" creationId="{753330F2-7F81-49E9-A7E1-1B9967B1EE4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7" creationId="{363011DF-A62E-495D-8A80-DCFABCF6F4F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8" creationId="{0E8FE107-8389-47B0-ABFD-551713BB73C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09" creationId="{A907D551-FC54-44D8-A139-6EF82B7E955F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0" creationId="{91605E96-9D2A-4C27-A861-B893E8CE872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1" creationId="{27B307EA-94B6-4892-A14B-1FBC40728A4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2" creationId="{7C42A571-BF67-491E-8EBC-86674157513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3" creationId="{3197ABE6-9369-4351-8C5F-CAC07984BDE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4" creationId="{FD761B4E-7707-4560-94A9-21C9910A3DB3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5" creationId="{F988E9DF-DE2B-4B57-82C5-3554331049F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6" creationId="{57BFF560-5451-4A60-B5D6-B6B6DFB4122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7" creationId="{44494404-7E49-49EB-A32C-739F708D071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8" creationId="{08FAAAD6-B2CD-4044-B195-375BD831D94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19" creationId="{AD36A64F-8BE8-4D37-812B-BA7372142E4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0" creationId="{E8DE8B0D-03E6-400D-BC15-EA11702CB24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1" creationId="{AEC39AEF-04B5-4C2D-BE97-0265C1498EE4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2" creationId="{8190064B-B9A9-4D9E-B7EB-79E23C29286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3" creationId="{45BE89F4-2B0C-4F9D-B32E-98679183BE67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4" creationId="{D213BEF7-7D6A-487D-B601-C1EDA4C686E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5" creationId="{68E11F00-206D-483E-BA41-FAC19DDF423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6" creationId="{FBB93B8A-CAC9-406A-B929-B968A4F41E0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7" creationId="{B0BE20FB-BFE1-4B7A-94A5-FAC498CBB42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8" creationId="{FF45350F-A011-40CA-A8A9-074FA7E94ED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29" creationId="{043CBA9F-0609-4BB7-85C3-0A911CF63CE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0" creationId="{BE8F62CD-BE67-4A7D-A53B-DD49E9467A4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1" creationId="{D1871C47-BEDE-48A8-92F8-E1E4184706B2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2" creationId="{16071BF4-DB1C-41EE-A77C-9626BA75D60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3" creationId="{ECDE8CF0-6896-4E41-9D0E-8D424AEAC47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4" creationId="{60142403-A71F-4AC0-9A32-9BFE42FD900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5" creationId="{A213E2B9-36E2-4042-97C6-539ECF005F3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6" creationId="{AF5AC61B-CC44-4E23-9638-FE184C9354E3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7" creationId="{B5CA2D01-B97A-4F5A-9B6D-25AE0431451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8" creationId="{1DDA04FC-4325-445E-8031-F17090E5B2F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39" creationId="{BB863A5C-F88A-4661-B130-BE0DC01503E6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0" creationId="{86F89863-E75E-4C67-87CE-8C707A9F7E8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1" creationId="{4CF1A6E8-C6EB-4AFE-BF4B-911AC455F5E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2" creationId="{1CFE185D-259B-473B-A389-27AB9F38595A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3" creationId="{2982D1E8-7A96-4C2C-8E6C-C7567CBD1081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4" creationId="{ABB1BA13-7744-4CF0-B957-ED8A4B44C2AE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5" creationId="{A213BD46-1DA9-43D5-8037-3EEA10FB014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6" creationId="{61AFD4D7-A038-42DB-922D-FE30EE72106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7" creationId="{1A222363-6C94-4EAD-BF6A-408E8736E9F0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8" creationId="{6B23046D-0849-421D-81E0-D4EDDDA85535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49" creationId="{BEA14DAD-3DBA-49BF-B187-0052F972A48D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0" creationId="{36AAF28A-B6A6-4D7B-854C-6D2324561F03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1" creationId="{1C8B206E-623B-4499-A239-230B873D6108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2" creationId="{C8B4AC44-1FB9-448E-A3CB-383FA5EDB01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3" creationId="{9D1DE798-8912-4125-BB2E-D6667BE644FC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4" creationId="{64D6AE8C-F758-4BA0-8639-1CD4F9BA342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5" creationId="{53CAA2DA-38FE-415E-B1E5-89382EAB607B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6" creationId="{1593B1D3-F107-48EF-AEB7-BA990CF05859}"/>
          </ac:spMkLst>
        </pc:spChg>
        <pc:spChg chg="mod">
          <ac:chgData name="Daniel Rico" userId="0a475d9e3b43bc68" providerId="LiveId" clId="{270B1BA4-9F87-4EF9-905B-DA0AFE67291F}" dt="2020-11-22T07:22:32.155" v="66" actId="338"/>
          <ac:spMkLst>
            <pc:docMk/>
            <pc:sldMk cId="3010957323" sldId="306"/>
            <ac:spMk id="857" creationId="{80079868-6F69-48D7-81E6-B73BF494195F}"/>
          </ac:spMkLst>
        </pc:spChg>
        <pc:grpChg chg="mod">
          <ac:chgData name="Daniel Rico" userId="0a475d9e3b43bc68" providerId="LiveId" clId="{270B1BA4-9F87-4EF9-905B-DA0AFE67291F}" dt="2020-11-22T07:22:32.155" v="66" actId="338"/>
          <ac:grpSpMkLst>
            <pc:docMk/>
            <pc:sldMk cId="3010957323" sldId="306"/>
            <ac:grpSpMk id="1" creationId="{00000000-0000-0000-0000-000000000000}"/>
          </ac:grpSpMkLst>
        </pc:grpChg>
        <pc:grpChg chg="mod">
          <ac:chgData name="Daniel Rico" userId="0a475d9e3b43bc68" providerId="LiveId" clId="{270B1BA4-9F87-4EF9-905B-DA0AFE67291F}" dt="2020-11-22T07:18:20.162" v="26" actId="338"/>
          <ac:grpSpMkLst>
            <pc:docMk/>
            <pc:sldMk cId="3010957323" sldId="306"/>
            <ac:grpSpMk id="2" creationId="{A7EC893D-D7B1-41C1-BD03-A6DFE9CC4CF0}"/>
          </ac:grpSpMkLst>
        </pc:grpChg>
        <pc:grpChg chg="add mod">
          <ac:chgData name="Daniel Rico" userId="0a475d9e3b43bc68" providerId="LiveId" clId="{270B1BA4-9F87-4EF9-905B-DA0AFE67291F}" dt="2020-11-22T07:54:39.907" v="104" actId="1076"/>
          <ac:grpSpMkLst>
            <pc:docMk/>
            <pc:sldMk cId="3010957323" sldId="306"/>
            <ac:grpSpMk id="3" creationId="{95891274-58B0-4EEE-AAA6-E1E596DCFD18}"/>
          </ac:grpSpMkLst>
        </pc:grpChg>
        <pc:grpChg chg="add del mod">
          <ac:chgData name="Daniel Rico" userId="0a475d9e3b43bc68" providerId="LiveId" clId="{270B1BA4-9F87-4EF9-905B-DA0AFE67291F}" dt="2020-11-22T07:18:54.932" v="33" actId="165"/>
          <ac:grpSpMkLst>
            <pc:docMk/>
            <pc:sldMk cId="3010957323" sldId="306"/>
            <ac:grpSpMk id="7" creationId="{E63F3C7B-20E7-49AF-AD01-E56969B23DAE}"/>
          </ac:grpSpMkLst>
        </pc:grpChg>
        <pc:grpChg chg="add del mod">
          <ac:chgData name="Daniel Rico" userId="0a475d9e3b43bc68" providerId="LiveId" clId="{270B1BA4-9F87-4EF9-905B-DA0AFE67291F}" dt="2020-11-22T07:22:38.085" v="68" actId="478"/>
          <ac:grpSpMkLst>
            <pc:docMk/>
            <pc:sldMk cId="3010957323" sldId="306"/>
            <ac:grpSpMk id="662" creationId="{079C4266-0638-4851-AEE7-553F129C4E2B}"/>
          </ac:grpSpMkLst>
        </pc:grpChg>
        <pc:picChg chg="add mod ord modCrop">
          <ac:chgData name="Daniel Rico" userId="0a475d9e3b43bc68" providerId="LiveId" clId="{270B1BA4-9F87-4EF9-905B-DA0AFE67291F}" dt="2020-11-22T07:54:27.016" v="101" actId="732"/>
          <ac:picMkLst>
            <pc:docMk/>
            <pc:sldMk cId="3010957323" sldId="306"/>
            <ac:picMk id="2" creationId="{97FF605E-3373-4268-BDDE-E106C5DC0AEB}"/>
          </ac:picMkLst>
        </pc:picChg>
        <pc:picChg chg="add del mod topLvl">
          <ac:chgData name="Daniel Rico" userId="0a475d9e3b43bc68" providerId="LiveId" clId="{270B1BA4-9F87-4EF9-905B-DA0AFE67291F}" dt="2020-11-22T07:52:52.297" v="94" actId="478"/>
          <ac:picMkLst>
            <pc:docMk/>
            <pc:sldMk cId="3010957323" sldId="306"/>
            <ac:picMk id="5" creationId="{DE9BC49E-7E70-438D-A4CB-82F1D51217EC}"/>
          </ac:picMkLst>
        </pc:picChg>
      </pc:sldChg>
      <pc:sldChg chg="modSp mod">
        <pc:chgData name="Daniel Rico" userId="0a475d9e3b43bc68" providerId="LiveId" clId="{270B1BA4-9F87-4EF9-905B-DA0AFE67291F}" dt="2020-11-22T07:57:28.443" v="125" actId="14100"/>
        <pc:sldMkLst>
          <pc:docMk/>
          <pc:sldMk cId="1829397131" sldId="312"/>
        </pc:sldMkLst>
        <pc:graphicFrameChg chg="mod modGraphic">
          <ac:chgData name="Daniel Rico" userId="0a475d9e3b43bc68" providerId="LiveId" clId="{270B1BA4-9F87-4EF9-905B-DA0AFE67291F}" dt="2020-11-22T07:57:28.443" v="125" actId="14100"/>
          <ac:graphicFrameMkLst>
            <pc:docMk/>
            <pc:sldMk cId="1829397131" sldId="312"/>
            <ac:graphicFrameMk id="10" creationId="{BF6F9296-812C-4FDC-ACFF-459A61C3AE68}"/>
          </ac:graphicFrameMkLst>
        </pc:graphicFrameChg>
      </pc:sldChg>
      <pc:sldChg chg="addSp modSp new del mod">
        <pc:chgData name="Daniel Rico" userId="0a475d9e3b43bc68" providerId="LiveId" clId="{270B1BA4-9F87-4EF9-905B-DA0AFE67291F}" dt="2020-11-22T15:15:48.808" v="192" actId="47"/>
        <pc:sldMkLst>
          <pc:docMk/>
          <pc:sldMk cId="1164325507" sldId="313"/>
        </pc:sldMkLst>
        <pc:spChg chg="add mod">
          <ac:chgData name="Daniel Rico" userId="0a475d9e3b43bc68" providerId="LiveId" clId="{270B1BA4-9F87-4EF9-905B-DA0AFE67291F}" dt="2020-11-22T11:00:52.199" v="183" actId="20577"/>
          <ac:spMkLst>
            <pc:docMk/>
            <pc:sldMk cId="1164325507" sldId="313"/>
            <ac:spMk id="3" creationId="{D7440602-334E-4B2E-A9E5-EFB2EBBE1876}"/>
          </ac:spMkLst>
        </pc:spChg>
      </pc:sldChg>
      <pc:sldChg chg="addSp delSp modSp new del mod">
        <pc:chgData name="Daniel Rico" userId="0a475d9e3b43bc68" providerId="LiveId" clId="{270B1BA4-9F87-4EF9-905B-DA0AFE67291F}" dt="2020-11-22T07:54:43.907" v="105" actId="47"/>
        <pc:sldMkLst>
          <pc:docMk/>
          <pc:sldMk cId="3753657877" sldId="313"/>
        </pc:sldMkLst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" creationId="{44AD0A59-9F5F-4CC6-8E4E-7E18123622E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" creationId="{8A8EF878-5752-4C24-AEBD-13B708732E34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" creationId="{B640FA4D-FB2C-47E2-BA71-1C489B917264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" creationId="{E0099A0A-203D-4319-93DC-F8451C180C4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" creationId="{5BE8BCA6-C45A-4006-BA86-6E52F140011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" creationId="{5F914DC0-633F-4A50-AEB3-184712EBA4D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" creationId="{C52779D9-A348-4100-8E3E-2A629976B68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" creationId="{E106A418-6D1F-4069-8E50-8470A14FC38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" creationId="{B40B0FA8-7CB3-45F8-9C43-694C1694717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" creationId="{9D39C028-1667-4AF2-8FB1-B65D1511FFD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" creationId="{F3F36396-AE29-4306-8A10-27527FD1BB0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" creationId="{82DB6CE0-8D45-4669-9FB3-2D5231CEA61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" creationId="{0DCF3058-0642-4C07-955E-7CC23E9159C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" creationId="{58E5CBAC-0058-4595-A2BB-B5D10846B92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" creationId="{4A8F8FC5-4C0D-4A11-935D-5CB1BED7FE3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0" creationId="{519E72E8-A2E7-4645-9572-70CF5CD9CF9D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1" creationId="{2CE661EC-186F-4339-83AD-EBFAF14B322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2" creationId="{C676DE32-5441-4E21-88AC-EBC0D81E677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3" creationId="{1FC35FF5-879B-4FA7-8991-1042C5D2F45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4" creationId="{9FF29F5B-89A8-457B-AE9C-D92868CF3BA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5" creationId="{9CE2090E-C478-4E13-A37B-8E81572E85C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6" creationId="{330958F7-9E91-4B46-96A5-7A3E8203356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7" creationId="{BC16A2EC-FFA2-4993-8C4B-8FD674DFBE0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8" creationId="{E0637B83-1B3D-452C-87B6-C47A6410F8B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29" creationId="{2F1BB8FE-E580-4B01-AFF1-22D3C6A0BAE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0" creationId="{A4AABB2C-A41A-47BD-912E-AC29D8BAF5A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1" creationId="{BCAD8474-BCB6-4B83-B86D-D4B9285A6A9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2" creationId="{9C475948-B085-49A0-AC44-2D21CBBC174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3" creationId="{57DB637B-C439-498F-880D-31CBB2542B7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4" creationId="{FD955811-E4CB-4AD5-8AF1-994BE9ADB76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5" creationId="{29AF9876-0A2E-4E53-BC39-F1B2BD1BD0F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6" creationId="{0597915C-15E1-4E82-B6F6-ED5852DB12B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7" creationId="{85BD881A-1A8A-4E2A-960B-6C69B50DFD2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8" creationId="{5DFD632D-32CF-4117-B2F7-78D5C8D8D2E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39" creationId="{3DF847F5-7E50-4344-8F78-02FECF39FE7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0" creationId="{8AEE6814-B754-4913-8F32-72321997A1F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1" creationId="{4636464F-5EB6-4A56-AD3C-ED8BB8C162D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2" creationId="{CC2C4D66-4510-4868-AECC-ABAD134BC074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3" creationId="{2906F1CD-A90B-4399-AD36-8E936C5A8C6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4" creationId="{61FB0387-2F87-431B-8C44-961C3B7F420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5" creationId="{5EE58C08-6CE5-46B0-8FC0-458B0587B18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6" creationId="{59633335-9C22-4C51-ACA2-17A20B0B880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7" creationId="{AC388C15-D53A-4D81-94D4-E2594FA0CC5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8" creationId="{974DA66A-2B81-46C2-B22B-0D834FEE447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49" creationId="{86FBF1B1-84D4-4DB0-A698-75229E41C7D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0" creationId="{AAB81F77-D87E-463F-B488-43A7626A481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1" creationId="{2C41C616-37F9-4E75-A253-17BB473B133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2" creationId="{7B82BBEF-2B1E-4CF4-BAEB-BC690B2E0E9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3" creationId="{94408E70-7C94-4099-B953-C4FBCA48B85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4" creationId="{FB03B00B-867A-41BE-AD80-61DDCA75174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5" creationId="{6618F96A-E086-41F8-B2F0-640417FFB49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6" creationId="{036A0A3A-7728-49AB-9F09-217FDA1C5BB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7" creationId="{B991FB00-CF16-4B88-81BB-0986897E9D9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8" creationId="{862FB0BA-E562-4952-A376-0104B0628DB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59" creationId="{F33C5EA9-E711-44F8-B3B1-5CA85B6D311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0" creationId="{A9453DE4-5701-4CFD-BB92-55BD5A3666B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1" creationId="{0264F4F4-02C7-4B5E-B1B8-80D43EBA6DB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2" creationId="{113D42D9-19CB-46D7-A121-7BFF60BB54E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3" creationId="{E2B93560-29FB-445F-86D3-552E27FF827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4" creationId="{2DC21870-A49A-4FD0-A207-5382B9A84BE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5" creationId="{FE7A6692-07A9-456C-9277-026053D02B48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6" creationId="{A4BA4079-EA05-43D9-9B61-2A3AA258F89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7" creationId="{AEE35DC1-CD6F-4DB1-BFDD-35A9B5EE764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8" creationId="{F0B3D66D-0BBA-4556-B338-4BE2B0FE874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69" creationId="{7735AC68-AC56-4497-A027-62814FFE9D0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0" creationId="{CDBD579E-8D18-4042-8763-9FDBB48FDFF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1" creationId="{0C870E43-4535-4613-AD25-86CA8603875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2" creationId="{068B44E5-B3DA-45C3-91CF-63CEA9D2410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3" creationId="{9873C08D-88FF-40B0-BF1A-BAF5FC2DBAE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4" creationId="{004437D9-CDF6-4B88-9134-DD5F230F10A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5" creationId="{14863866-E43F-449A-8600-8431EEF53958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6" creationId="{F1665B43-B807-4141-BF7A-98E073289DC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7" creationId="{347C5CB4-4803-48A6-BD5C-9D9AA62F4F1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8" creationId="{792C19F6-60C2-43F1-AB81-53AF03B9AA3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79" creationId="{8871F01A-6A2C-4C36-A472-8124E8C5841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0" creationId="{0641DC9D-571C-4B5A-AD0E-41670B391C6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1" creationId="{35B8E730-40F4-4A9C-818B-69F668FB5C3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2" creationId="{26568FD5-808E-4E6B-BA76-8CB545F9124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3" creationId="{92A1BB9A-1DFD-4AA8-B4C1-F843693C945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4" creationId="{5685C6DF-4C23-4E54-9347-8A34EE505CA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5" creationId="{496DCD48-1DA6-493B-948A-1081188A616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6" creationId="{AC4CC37E-BC8B-406F-AFFF-AC1A157BB52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7" creationId="{972C0183-C640-428E-8675-DFAA17CC9B9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8" creationId="{7E8C3DD7-DED1-40CC-BA65-B0F168D5918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89" creationId="{D640232A-1B1A-4BBC-8717-3E797C5720B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0" creationId="{214EE8AD-FAD9-445D-84EF-CDC159B6FB6D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1" creationId="{53579F2C-AE0D-496B-8FEA-CCD6AA9ED8E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2" creationId="{450C8A1C-3299-4A6D-A8F3-2D8EDF469C6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3" creationId="{2F7765A0-F07E-4BBF-A745-2C62D9B4A94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4" creationId="{1F7633DE-E1B6-4F30-8406-1300E40E861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5" creationId="{6503F81B-C976-47F1-9E24-666D427E0EE8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6" creationId="{1D3D5E24-5B9D-4482-807A-69BB1FBE55F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7" creationId="{F71D0A11-AF81-4AA8-AF5E-09007C248E4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8" creationId="{5BE6EAC9-ADF4-494F-86D5-9D77614A6DE8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99" creationId="{0124DA47-9BC8-4496-8A64-8A1B35759D2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0" creationId="{C9EDE7B4-0CD3-4711-856E-42BEB58E50A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1" creationId="{C0BCAFED-38FB-4946-9FB4-3174BF92290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2" creationId="{AEE1CFCC-FA3B-4150-B3A3-8DD9A6666AA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3" creationId="{B62BDCAF-099A-4712-AF26-7211D991F7C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4" creationId="{00E20A7C-CD39-411C-8555-E7EB3CF6EAB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5" creationId="{E7248BFE-0145-43E0-922B-971FF26CA41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6" creationId="{72CD7AF5-2029-4B77-9A95-00C8D01FA6E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7" creationId="{6250B3BB-A229-4121-BAE7-005387DD1F5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8" creationId="{04FA2362-2345-4277-B574-D817F05FE52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09" creationId="{F20498FC-E509-432B-BD57-8AC393E1930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0" creationId="{962125AC-9429-47D5-A170-BC050E81F8F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1" creationId="{7F79E3DA-F251-4C8E-AB5D-4EF32889E82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2" creationId="{AD5170BB-46C3-4619-9103-3756B9FBBE68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3" creationId="{8426E545-732A-49F3-9704-0724C434160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4" creationId="{80EF3C2E-CDA3-477A-825A-558F30CDAA1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5" creationId="{F46FB9A4-E4C8-41B2-842F-C76291418AB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6" creationId="{872DF93A-AF49-443B-8F98-9AEE0768ED4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7" creationId="{B9102E12-9A12-4AAC-B631-92263EAC3EA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8" creationId="{F0D76D24-EA33-407B-8F8A-C2C84316F71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19" creationId="{96494099-815C-431D-A9B7-087A0BB77E6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0" creationId="{67578D75-C4CC-4E1B-A228-E8104A1F823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1" creationId="{46FF7887-6409-4B4F-8E5B-5A9DCB52C3F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2" creationId="{32B64239-EFF5-4BA4-AB49-CACCC0F93B3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3" creationId="{1F1ADF40-10B5-442C-81B8-400CC4BCF63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4" creationId="{6A61F776-4EA3-4FA3-B0A8-1075D3CD67F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5" creationId="{2D3620D4-87EA-40DC-8E78-AE7DA646F1B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6" creationId="{E208E0EB-08BB-4FD9-9675-CBACC98C20B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7" creationId="{F1DEFBCF-1B99-440D-BC37-D4EAB5CD319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8" creationId="{2EC4CC6A-2C13-499B-A8EA-E235C6EAC70D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29" creationId="{BFEACEA0-84BC-4C11-A44D-4F2A9503CC0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0" creationId="{0EE90B7C-663C-410D-83BF-8924C3C4C93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1" creationId="{FAA6FCC7-6B9C-406B-A82A-9496DD3411A4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2" creationId="{D2925F71-0D77-4F94-B314-6DCEFD4C357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3" creationId="{9E0990DC-39AB-410A-86AD-4052A79F13F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4" creationId="{6BA55FFC-6A9C-45D4-A67B-710ED77D279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5" creationId="{4074DC89-4FAD-4CC6-8F79-2A072167FC9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6" creationId="{E3B9965C-6396-40D2-8E35-7F133168D8D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7" creationId="{9EB2E4D9-1742-4752-846C-C53C0594EDE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8" creationId="{ADFF885F-DE65-466D-93F2-855B3CA3E81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39" creationId="{7DD64543-79FF-4D1F-8B99-2D104A6400A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0" creationId="{29475AEA-A6E8-493C-9E9B-890112B4B49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1" creationId="{40AD4762-15D2-42B3-B8B9-25474ADBC76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2" creationId="{BC215EA4-94CF-4167-BE31-A19B28E5B71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3" creationId="{14EE08BE-0384-4308-B9B1-1FD0C84FB38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4" creationId="{D46B14A5-BF75-40CC-B8C0-08DC35CF684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5" creationId="{B1C0BD71-60A2-42EF-9C4D-93DC0FD6EF6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6" creationId="{E5E388AA-C31B-4801-BEA0-B01532A4205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7" creationId="{B3E996AF-A8B7-4A82-8410-90450C3A305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8" creationId="{DFC2199D-281D-4152-B836-DB61F0117C1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49" creationId="{B7E853CE-F1DB-450E-97CC-CE34538DBB0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0" creationId="{454BC1F5-7B8D-4219-AAE7-8D3B7EDC9C2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1" creationId="{6870B26F-0EDA-4707-A6F2-299F0FED747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2" creationId="{4BBE49E8-4FF7-4025-8C8A-4A03D8AA8B4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3" creationId="{4AC0E300-1CCC-4927-AE25-6DAA4010E65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4" creationId="{38E925B3-FD6B-4E82-AC6C-AC2B8CEA3EA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5" creationId="{B6A5DA03-8BA2-4798-B183-125011EBD01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6" creationId="{8823EE75-0AB9-43FE-9A28-C3EF907A289D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7" creationId="{4FA6A3B5-E054-4D6A-9DCC-F5647852FF3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8" creationId="{13AC61E9-6F0C-4A6D-A793-3862AC7D24F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59" creationId="{B9C63355-5F4F-433A-8B1B-388E4322FA2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0" creationId="{BD5AB937-C4D0-409C-884F-9C9704731E3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1" creationId="{BCF4407B-DDDF-443B-9979-4CE1B64C933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2" creationId="{ABBAF891-46AE-4800-BCFE-022941C2F41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3" creationId="{0E459142-2A6A-4CCC-A938-BC5388B532B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4" creationId="{03E40759-9E54-4C46-BF7D-D5635BD19A0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5" creationId="{BEA91A48-57E1-444A-922B-3215A49703D1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6" creationId="{049F612A-8F12-4FE3-92D1-E5E535D8B0F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7" creationId="{5E3B15B0-01DD-49EB-B762-2F4FF76DDEB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8" creationId="{D7C4576D-92F9-4721-9A94-914A311FB08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69" creationId="{7CEF30C0-D938-4909-B5F5-97C01F9014D4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0" creationId="{F362120E-1828-4054-92E0-F8D963C7699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1" creationId="{14B5F7BE-0C38-4FAD-B9F6-E34A9BFB9B92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2" creationId="{094D54F8-658B-4B67-9AA4-174348D612D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3" creationId="{582D8904-68B2-4C7D-9D95-6DA16F667E09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4" creationId="{622DA622-7375-44A7-B399-19156B0EB23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5" creationId="{9FD1DFD5-87EE-47A5-AFFC-50416D706817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6" creationId="{4BB22A93-49E8-4466-976B-2F47757656D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7" creationId="{5EBAD11F-1FF4-41D5-985A-75D573543C6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8" creationId="{A1772769-FC8F-4F57-ACB2-2F6AE7F66934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79" creationId="{D445AC4D-D711-4CDE-B3C4-E1936C2321E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0" creationId="{4BF807F7-EB01-4993-83C2-F075C7BCA5F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1" creationId="{A053E285-2DA0-4912-B6B5-A7ADA79FE86D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2" creationId="{03590525-490C-4A3C-AA96-C7018B95CDA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3" creationId="{D270618B-C699-41D5-BB0D-8458E2F1114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4" creationId="{DF54BBC8-88B3-4B6E-8F1C-B3AF6D46563A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5" creationId="{DFF4F444-37D4-45DF-B57C-1FFDCEFB7DA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6" creationId="{EAC89E28-9643-4154-97F1-9DF6CFB4BFE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7" creationId="{EA3846CC-308C-4449-9E69-842CC2426CD0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8" creationId="{981017F2-1E0D-41D3-99E3-A142BEFE6A7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89" creationId="{8BAD35EC-0841-4841-9181-9FA617476B9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0" creationId="{6F40CDAF-10F5-45BB-975E-BDD1E551271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1" creationId="{F3ADC032-9114-4AA2-9746-E0C04D1A3AB3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2" creationId="{83FBF68C-D590-42A2-AE46-43F79A85366B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3" creationId="{6F8A890A-00B8-47D5-854F-160FAA39782C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4" creationId="{2105FB5D-C039-4415-80D2-3FDA02594486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5" creationId="{6207ADD7-7544-44B3-ACE6-6A59A8AFA85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6" creationId="{B1B128F4-88CC-43A4-8612-DC4B68854DDF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7" creationId="{210A3F2B-DF32-4AEB-B572-05D7BD235875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8" creationId="{C7B69B10-0107-4DFA-ADA5-C77639E061FE}"/>
          </ac:spMkLst>
        </pc:spChg>
        <pc:spChg chg="add del mod topLvl">
          <ac:chgData name="Daniel Rico" userId="0a475d9e3b43bc68" providerId="LiveId" clId="{270B1BA4-9F87-4EF9-905B-DA0AFE67291F}" dt="2020-11-22T07:53:18.282" v="95" actId="164"/>
          <ac:spMkLst>
            <pc:docMk/>
            <pc:sldMk cId="3753657877" sldId="313"/>
            <ac:spMk id="199" creationId="{8A823230-B349-4F68-8336-669032E64774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1" creationId="{1A1C7EAA-92AA-4E91-94E3-940636F52101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2" creationId="{03226BDE-F5A4-4AB2-86CD-02E35441B360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3" creationId="{93C10288-C1A1-40DA-BC08-CDC4C0E5D4E2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4" creationId="{AE851DC1-FD6F-46AB-AAF0-9FAA6E683206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5" creationId="{7AF5E8B4-8567-4204-9B46-1C6C98CEFB5A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6" creationId="{11579293-B037-42E8-9A53-759D2FF32578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7" creationId="{86E46CCA-3378-4B2C-BE3E-80E0E77749BA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8" creationId="{8CBA75FB-DCEA-4B3E-BBE8-E1CD99129A1B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09" creationId="{F79140D9-225F-41FE-A04C-752F3E5A748B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10" creationId="{1D3E0094-B3F7-4FF5-B500-65C03C228CB7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11" creationId="{B6ED6F40-2C44-40FC-B47C-0E8C405F95B8}"/>
          </ac:spMkLst>
        </pc:spChg>
        <pc:spChg chg="add del mod">
          <ac:chgData name="Daniel Rico" userId="0a475d9e3b43bc68" providerId="LiveId" clId="{270B1BA4-9F87-4EF9-905B-DA0AFE67291F}" dt="2020-11-22T07:22:02.051" v="62"/>
          <ac:spMkLst>
            <pc:docMk/>
            <pc:sldMk cId="3753657877" sldId="313"/>
            <ac:spMk id="212" creationId="{D288C652-6D55-4F9E-A179-566F37D6A917}"/>
          </ac:spMkLst>
        </pc:spChg>
        <pc:grpChg chg="mod">
          <ac:chgData name="Daniel Rico" userId="0a475d9e3b43bc68" providerId="LiveId" clId="{270B1BA4-9F87-4EF9-905B-DA0AFE67291F}" dt="2020-11-22T07:19:35.056" v="40" actId="338"/>
          <ac:grpSpMkLst>
            <pc:docMk/>
            <pc:sldMk cId="3753657877" sldId="313"/>
            <ac:grpSpMk id="1" creationId="{00000000-0000-0000-0000-000000000000}"/>
          </ac:grpSpMkLst>
        </pc:grpChg>
        <pc:grpChg chg="add mod">
          <ac:chgData name="Daniel Rico" userId="0a475d9e3b43bc68" providerId="LiveId" clId="{270B1BA4-9F87-4EF9-905B-DA0AFE67291F}" dt="2020-11-22T07:53:18.282" v="95" actId="164"/>
          <ac:grpSpMkLst>
            <pc:docMk/>
            <pc:sldMk cId="3753657877" sldId="313"/>
            <ac:grpSpMk id="2" creationId="{0036667E-AAD0-4692-B6C9-35412F43C195}"/>
          </ac:grpSpMkLst>
        </pc:grpChg>
        <pc:grpChg chg="del mod">
          <ac:chgData name="Daniel Rico" userId="0a475d9e3b43bc68" providerId="LiveId" clId="{270B1BA4-9F87-4EF9-905B-DA0AFE67291F}" dt="2020-11-22T07:19:40.419" v="41" actId="165"/>
          <ac:grpSpMkLst>
            <pc:docMk/>
            <pc:sldMk cId="3753657877" sldId="313"/>
            <ac:grpSpMk id="4" creationId="{A9E4F82C-6EF3-4748-994A-E22F8FEB967E}"/>
          </ac:grpSpMkLst>
        </pc:grpChg>
        <pc:picChg chg="add del">
          <ac:chgData name="Daniel Rico" userId="0a475d9e3b43bc68" providerId="LiveId" clId="{270B1BA4-9F87-4EF9-905B-DA0AFE67291F}" dt="2020-11-22T07:19:26.810" v="38"/>
          <ac:picMkLst>
            <pc:docMk/>
            <pc:sldMk cId="3753657877" sldId="313"/>
            <ac:picMk id="2" creationId="{9591ADAB-6BBB-48AB-BAFF-382BA3AB62B0}"/>
          </ac:picMkLst>
        </pc:picChg>
        <pc:picChg chg="add del mod">
          <ac:chgData name="Daniel Rico" userId="0a475d9e3b43bc68" providerId="LiveId" clId="{270B1BA4-9F87-4EF9-905B-DA0AFE67291F}" dt="2020-11-22T07:19:35.056" v="40" actId="338"/>
          <ac:picMkLst>
            <pc:docMk/>
            <pc:sldMk cId="3753657877" sldId="313"/>
            <ac:picMk id="3" creationId="{B88FAC3F-79F9-432E-AEDE-23A684A08B97}"/>
          </ac:picMkLst>
        </pc:picChg>
        <pc:picChg chg="add del mod">
          <ac:chgData name="Daniel Rico" userId="0a475d9e3b43bc68" providerId="LiveId" clId="{270B1BA4-9F87-4EF9-905B-DA0AFE67291F}" dt="2020-11-22T07:21:38.207" v="59" actId="478"/>
          <ac:picMkLst>
            <pc:docMk/>
            <pc:sldMk cId="3753657877" sldId="313"/>
            <ac:picMk id="200" creationId="{1A39DFBC-D4FF-41B3-B60E-3F2D48E48651}"/>
          </ac:picMkLst>
        </pc:picChg>
      </pc:sldChg>
      <pc:sldChg chg="new del">
        <pc:chgData name="Daniel Rico" userId="0a475d9e3b43bc68" providerId="LiveId" clId="{270B1BA4-9F87-4EF9-905B-DA0AFE67291F}" dt="2020-11-22T07:23:31.459" v="70" actId="47"/>
        <pc:sldMkLst>
          <pc:docMk/>
          <pc:sldMk cId="3068077432" sldId="314"/>
        </pc:sldMkLst>
      </pc:sldChg>
    </pc:docChg>
  </pc:docChgLst>
  <pc:docChgLst>
    <pc:chgData name="Daniel Rico" userId="0a475d9e3b43bc68" providerId="LiveId" clId="{033398EC-C951-4AC8-BF7E-678ADC764D8A}"/>
    <pc:docChg chg="undo redo custSel modSld">
      <pc:chgData name="Daniel Rico" userId="0a475d9e3b43bc68" providerId="LiveId" clId="{033398EC-C951-4AC8-BF7E-678ADC764D8A}" dt="2020-11-22T19:43:45.214" v="745" actId="20577"/>
      <pc:docMkLst>
        <pc:docMk/>
      </pc:docMkLst>
      <pc:sldChg chg="modSp mod">
        <pc:chgData name="Daniel Rico" userId="0a475d9e3b43bc68" providerId="LiveId" clId="{033398EC-C951-4AC8-BF7E-678ADC764D8A}" dt="2020-11-22T18:33:59.609" v="238"/>
        <pc:sldMkLst>
          <pc:docMk/>
          <pc:sldMk cId="1717539364" sldId="256"/>
        </pc:sldMkLst>
        <pc:spChg chg="mod">
          <ac:chgData name="Daniel Rico" userId="0a475d9e3b43bc68" providerId="LiveId" clId="{033398EC-C951-4AC8-BF7E-678ADC764D8A}" dt="2020-11-22T18:33:59.609" v="238"/>
          <ac:spMkLst>
            <pc:docMk/>
            <pc:sldMk cId="1717539364" sldId="256"/>
            <ac:spMk id="13" creationId="{E0E178D0-1489-4419-B8DF-3C654D215D4E}"/>
          </ac:spMkLst>
        </pc:spChg>
      </pc:sldChg>
      <pc:sldChg chg="modSp mod">
        <pc:chgData name="Daniel Rico" userId="0a475d9e3b43bc68" providerId="LiveId" clId="{033398EC-C951-4AC8-BF7E-678ADC764D8A}" dt="2020-11-22T19:43:45.214" v="745" actId="20577"/>
        <pc:sldMkLst>
          <pc:docMk/>
          <pc:sldMk cId="2238191415" sldId="292"/>
        </pc:sldMkLst>
        <pc:graphicFrameChg chg="modGraphic">
          <ac:chgData name="Daniel Rico" userId="0a475d9e3b43bc68" providerId="LiveId" clId="{033398EC-C951-4AC8-BF7E-678ADC764D8A}" dt="2020-11-22T19:43:45.214" v="745" actId="20577"/>
          <ac:graphicFrameMkLst>
            <pc:docMk/>
            <pc:sldMk cId="2238191415" sldId="292"/>
            <ac:graphicFrameMk id="3" creationId="{D1C4F5C1-E03D-4EAB-9936-3CECBF519626}"/>
          </ac:graphicFrameMkLst>
        </pc:graphicFrameChg>
      </pc:sldChg>
      <pc:sldChg chg="modSp mod">
        <pc:chgData name="Daniel Rico" userId="0a475d9e3b43bc68" providerId="LiveId" clId="{033398EC-C951-4AC8-BF7E-678ADC764D8A}" dt="2020-11-22T18:59:52.600" v="371" actId="20577"/>
        <pc:sldMkLst>
          <pc:docMk/>
          <pc:sldMk cId="3116392245" sldId="297"/>
        </pc:sldMkLst>
        <pc:spChg chg="mod">
          <ac:chgData name="Daniel Rico" userId="0a475d9e3b43bc68" providerId="LiveId" clId="{033398EC-C951-4AC8-BF7E-678ADC764D8A}" dt="2020-11-22T18:46:12.881" v="246" actId="20577"/>
          <ac:spMkLst>
            <pc:docMk/>
            <pc:sldMk cId="3116392245" sldId="297"/>
            <ac:spMk id="5" creationId="{71B287F6-CDDC-4796-98A0-64F4BD826BE4}"/>
          </ac:spMkLst>
        </pc:spChg>
        <pc:spChg chg="mod">
          <ac:chgData name="Daniel Rico" userId="0a475d9e3b43bc68" providerId="LiveId" clId="{033398EC-C951-4AC8-BF7E-678ADC764D8A}" dt="2020-11-22T18:46:20.424" v="250" actId="20577"/>
          <ac:spMkLst>
            <pc:docMk/>
            <pc:sldMk cId="3116392245" sldId="297"/>
            <ac:spMk id="6" creationId="{3119660E-5E46-41D9-AD16-46DE10C934B0}"/>
          </ac:spMkLst>
        </pc:spChg>
        <pc:spChg chg="mod">
          <ac:chgData name="Daniel Rico" userId="0a475d9e3b43bc68" providerId="LiveId" clId="{033398EC-C951-4AC8-BF7E-678ADC764D8A}" dt="2020-11-22T18:46:17.592" v="248" actId="20577"/>
          <ac:spMkLst>
            <pc:docMk/>
            <pc:sldMk cId="3116392245" sldId="297"/>
            <ac:spMk id="7" creationId="{53C7E1D3-E71B-4D9B-94D0-8C777F900699}"/>
          </ac:spMkLst>
        </pc:spChg>
        <pc:spChg chg="mod">
          <ac:chgData name="Daniel Rico" userId="0a475d9e3b43bc68" providerId="LiveId" clId="{033398EC-C951-4AC8-BF7E-678ADC764D8A}" dt="2020-11-22T18:46:24.144" v="252" actId="20577"/>
          <ac:spMkLst>
            <pc:docMk/>
            <pc:sldMk cId="3116392245" sldId="297"/>
            <ac:spMk id="9" creationId="{CA0ED2D2-70E3-4DBD-B1AC-3E00D3F934CB}"/>
          </ac:spMkLst>
        </pc:spChg>
        <pc:spChg chg="mod">
          <ac:chgData name="Daniel Rico" userId="0a475d9e3b43bc68" providerId="LiveId" clId="{033398EC-C951-4AC8-BF7E-678ADC764D8A}" dt="2020-11-22T18:46:27.012" v="254" actId="20577"/>
          <ac:spMkLst>
            <pc:docMk/>
            <pc:sldMk cId="3116392245" sldId="297"/>
            <ac:spMk id="11" creationId="{E90655F3-A560-4457-9E7A-2FD1DFBDF288}"/>
          </ac:spMkLst>
        </pc:spChg>
        <pc:spChg chg="mod">
          <ac:chgData name="Daniel Rico" userId="0a475d9e3b43bc68" providerId="LiveId" clId="{033398EC-C951-4AC8-BF7E-678ADC764D8A}" dt="2020-11-22T18:59:52.600" v="371" actId="20577"/>
          <ac:spMkLst>
            <pc:docMk/>
            <pc:sldMk cId="3116392245" sldId="297"/>
            <ac:spMk id="12" creationId="{C36FF3F3-EF19-412C-BC4E-4FCBF1928AED}"/>
          </ac:spMkLst>
        </pc:spChg>
      </pc:sldChg>
      <pc:sldChg chg="modSp mod">
        <pc:chgData name="Daniel Rico" userId="0a475d9e3b43bc68" providerId="LiveId" clId="{033398EC-C951-4AC8-BF7E-678ADC764D8A}" dt="2020-11-22T19:01:54.044" v="378" actId="6549"/>
        <pc:sldMkLst>
          <pc:docMk/>
          <pc:sldMk cId="2571561803" sldId="298"/>
        </pc:sldMkLst>
        <pc:spChg chg="mod">
          <ac:chgData name="Daniel Rico" userId="0a475d9e3b43bc68" providerId="LiveId" clId="{033398EC-C951-4AC8-BF7E-678ADC764D8A}" dt="2020-11-22T18:54:02.485" v="304" actId="20577"/>
          <ac:spMkLst>
            <pc:docMk/>
            <pc:sldMk cId="2571561803" sldId="298"/>
            <ac:spMk id="13" creationId="{436D561E-5B8D-4D98-B740-45BB2461D971}"/>
          </ac:spMkLst>
        </pc:spChg>
        <pc:spChg chg="mod">
          <ac:chgData name="Daniel Rico" userId="0a475d9e3b43bc68" providerId="LiveId" clId="{033398EC-C951-4AC8-BF7E-678ADC764D8A}" dt="2020-11-22T18:54:00.356" v="303" actId="20577"/>
          <ac:spMkLst>
            <pc:docMk/>
            <pc:sldMk cId="2571561803" sldId="298"/>
            <ac:spMk id="14" creationId="{E1933267-A82C-4800-BF1B-335D78EC1DB2}"/>
          </ac:spMkLst>
        </pc:spChg>
        <pc:spChg chg="mod">
          <ac:chgData name="Daniel Rico" userId="0a475d9e3b43bc68" providerId="LiveId" clId="{033398EC-C951-4AC8-BF7E-678ADC764D8A}" dt="2020-11-22T18:53:57.613" v="302" actId="20577"/>
          <ac:spMkLst>
            <pc:docMk/>
            <pc:sldMk cId="2571561803" sldId="298"/>
            <ac:spMk id="16" creationId="{DB499499-F910-4FCB-81BF-4DCA13573B43}"/>
          </ac:spMkLst>
        </pc:spChg>
        <pc:spChg chg="mod">
          <ac:chgData name="Daniel Rico" userId="0a475d9e3b43bc68" providerId="LiveId" clId="{033398EC-C951-4AC8-BF7E-678ADC764D8A}" dt="2020-11-22T18:53:55.625" v="301" actId="20577"/>
          <ac:spMkLst>
            <pc:docMk/>
            <pc:sldMk cId="2571561803" sldId="298"/>
            <ac:spMk id="17" creationId="{DEE30C6D-AC94-431C-87A0-90D91D178D41}"/>
          </ac:spMkLst>
        </pc:spChg>
        <pc:spChg chg="mod">
          <ac:chgData name="Daniel Rico" userId="0a475d9e3b43bc68" providerId="LiveId" clId="{033398EC-C951-4AC8-BF7E-678ADC764D8A}" dt="2020-11-22T18:53:52.453" v="300" actId="20577"/>
          <ac:spMkLst>
            <pc:docMk/>
            <pc:sldMk cId="2571561803" sldId="298"/>
            <ac:spMk id="18" creationId="{14D51F25-C4EE-47EA-AD62-3BA67B6272C7}"/>
          </ac:spMkLst>
        </pc:spChg>
        <pc:spChg chg="mod">
          <ac:chgData name="Daniel Rico" userId="0a475d9e3b43bc68" providerId="LiveId" clId="{033398EC-C951-4AC8-BF7E-678ADC764D8A}" dt="2020-11-22T18:58:05.459" v="350" actId="20577"/>
          <ac:spMkLst>
            <pc:docMk/>
            <pc:sldMk cId="2571561803" sldId="298"/>
            <ac:spMk id="21" creationId="{993A77AC-69FE-4818-A8B7-0BA8D6053A6A}"/>
          </ac:spMkLst>
        </pc:spChg>
        <pc:spChg chg="mod">
          <ac:chgData name="Daniel Rico" userId="0a475d9e3b43bc68" providerId="LiveId" clId="{033398EC-C951-4AC8-BF7E-678ADC764D8A}" dt="2020-11-22T18:58:00.019" v="348" actId="20577"/>
          <ac:spMkLst>
            <pc:docMk/>
            <pc:sldMk cId="2571561803" sldId="298"/>
            <ac:spMk id="23" creationId="{12E327AF-FCFD-4EEC-B0F3-38239C322FE8}"/>
          </ac:spMkLst>
        </pc:spChg>
        <pc:spChg chg="mod">
          <ac:chgData name="Daniel Rico" userId="0a475d9e3b43bc68" providerId="LiveId" clId="{033398EC-C951-4AC8-BF7E-678ADC764D8A}" dt="2020-11-22T18:58:11.776" v="354" actId="20577"/>
          <ac:spMkLst>
            <pc:docMk/>
            <pc:sldMk cId="2571561803" sldId="298"/>
            <ac:spMk id="25" creationId="{6FEB6825-C30C-408B-9248-25B8CA6CFFEF}"/>
          </ac:spMkLst>
        </pc:spChg>
        <pc:spChg chg="mod">
          <ac:chgData name="Daniel Rico" userId="0a475d9e3b43bc68" providerId="LiveId" clId="{033398EC-C951-4AC8-BF7E-678ADC764D8A}" dt="2020-11-22T18:57:48.312" v="343" actId="20577"/>
          <ac:spMkLst>
            <pc:docMk/>
            <pc:sldMk cId="2571561803" sldId="298"/>
            <ac:spMk id="26" creationId="{CA86C190-1036-49E2-9ED6-1069A9141F5A}"/>
          </ac:spMkLst>
        </pc:spChg>
        <pc:spChg chg="mod">
          <ac:chgData name="Daniel Rico" userId="0a475d9e3b43bc68" providerId="LiveId" clId="{033398EC-C951-4AC8-BF7E-678ADC764D8A}" dt="2020-11-22T18:57:19.843" v="331" actId="20577"/>
          <ac:spMkLst>
            <pc:docMk/>
            <pc:sldMk cId="2571561803" sldId="298"/>
            <ac:spMk id="27" creationId="{4D6C5C17-74B6-4813-AD6D-3C7F61436D8F}"/>
          </ac:spMkLst>
        </pc:spChg>
        <pc:spChg chg="mod">
          <ac:chgData name="Daniel Rico" userId="0a475d9e3b43bc68" providerId="LiveId" clId="{033398EC-C951-4AC8-BF7E-678ADC764D8A}" dt="2020-11-22T18:57:45.095" v="342" actId="20577"/>
          <ac:spMkLst>
            <pc:docMk/>
            <pc:sldMk cId="2571561803" sldId="298"/>
            <ac:spMk id="28" creationId="{0FF70DEF-A83E-4B4A-9E7C-2F2E7EA6E0DE}"/>
          </ac:spMkLst>
        </pc:spChg>
        <pc:spChg chg="mod">
          <ac:chgData name="Daniel Rico" userId="0a475d9e3b43bc68" providerId="LiveId" clId="{033398EC-C951-4AC8-BF7E-678ADC764D8A}" dt="2020-11-22T18:54:57.109" v="317" actId="20577"/>
          <ac:spMkLst>
            <pc:docMk/>
            <pc:sldMk cId="2571561803" sldId="298"/>
            <ac:spMk id="30" creationId="{057DEEEA-D228-49E3-BA57-B9ED1234A3A6}"/>
          </ac:spMkLst>
        </pc:spChg>
        <pc:spChg chg="mod">
          <ac:chgData name="Daniel Rico" userId="0a475d9e3b43bc68" providerId="LiveId" clId="{033398EC-C951-4AC8-BF7E-678ADC764D8A}" dt="2020-11-22T18:55:17.059" v="325" actId="20577"/>
          <ac:spMkLst>
            <pc:docMk/>
            <pc:sldMk cId="2571561803" sldId="298"/>
            <ac:spMk id="31" creationId="{F5F68160-62B2-439B-A540-2DC430B29CC1}"/>
          </ac:spMkLst>
        </pc:spChg>
        <pc:spChg chg="mod">
          <ac:chgData name="Daniel Rico" userId="0a475d9e3b43bc68" providerId="LiveId" clId="{033398EC-C951-4AC8-BF7E-678ADC764D8A}" dt="2020-11-22T18:54:59.891" v="318" actId="20577"/>
          <ac:spMkLst>
            <pc:docMk/>
            <pc:sldMk cId="2571561803" sldId="298"/>
            <ac:spMk id="32" creationId="{550456A8-4FA3-40F3-9218-2C33234B9687}"/>
          </ac:spMkLst>
        </pc:spChg>
        <pc:spChg chg="mod">
          <ac:chgData name="Daniel Rico" userId="0a475d9e3b43bc68" providerId="LiveId" clId="{033398EC-C951-4AC8-BF7E-678ADC764D8A}" dt="2020-11-22T18:55:13.556" v="323" actId="20577"/>
          <ac:spMkLst>
            <pc:docMk/>
            <pc:sldMk cId="2571561803" sldId="298"/>
            <ac:spMk id="33" creationId="{3B3C1594-B54C-43AB-BD16-7EC8737BCA0E}"/>
          </ac:spMkLst>
        </pc:spChg>
        <pc:spChg chg="mod">
          <ac:chgData name="Daniel Rico" userId="0a475d9e3b43bc68" providerId="LiveId" clId="{033398EC-C951-4AC8-BF7E-678ADC764D8A}" dt="2020-11-22T18:54:51.329" v="316" actId="20577"/>
          <ac:spMkLst>
            <pc:docMk/>
            <pc:sldMk cId="2571561803" sldId="298"/>
            <ac:spMk id="34" creationId="{48104BF0-8B19-4215-B870-2E658DEAE776}"/>
          </ac:spMkLst>
        </pc:spChg>
        <pc:spChg chg="mod">
          <ac:chgData name="Daniel Rico" userId="0a475d9e3b43bc68" providerId="LiveId" clId="{033398EC-C951-4AC8-BF7E-678ADC764D8A}" dt="2020-11-22T18:54:17.996" v="310" actId="20577"/>
          <ac:spMkLst>
            <pc:docMk/>
            <pc:sldMk cId="2571561803" sldId="298"/>
            <ac:spMk id="36" creationId="{66E2B025-BC00-49D6-B179-BA196943A04B}"/>
          </ac:spMkLst>
        </pc:spChg>
        <pc:spChg chg="mod">
          <ac:chgData name="Daniel Rico" userId="0a475d9e3b43bc68" providerId="LiveId" clId="{033398EC-C951-4AC8-BF7E-678ADC764D8A}" dt="2020-11-22T18:58:37.980" v="362" actId="20577"/>
          <ac:spMkLst>
            <pc:docMk/>
            <pc:sldMk cId="2571561803" sldId="298"/>
            <ac:spMk id="40" creationId="{AD3C83BC-F94D-4DE5-8C48-3D4196B7037D}"/>
          </ac:spMkLst>
        </pc:spChg>
        <pc:spChg chg="mod">
          <ac:chgData name="Daniel Rico" userId="0a475d9e3b43bc68" providerId="LiveId" clId="{033398EC-C951-4AC8-BF7E-678ADC764D8A}" dt="2020-11-22T18:58:26.284" v="356" actId="20577"/>
          <ac:spMkLst>
            <pc:docMk/>
            <pc:sldMk cId="2571561803" sldId="298"/>
            <ac:spMk id="42" creationId="{1474BCA4-798C-4369-AE8D-1D31035654D7}"/>
          </ac:spMkLst>
        </pc:spChg>
        <pc:spChg chg="mod">
          <ac:chgData name="Daniel Rico" userId="0a475d9e3b43bc68" providerId="LiveId" clId="{033398EC-C951-4AC8-BF7E-678ADC764D8A}" dt="2020-11-22T18:58:43.488" v="364" actId="20577"/>
          <ac:spMkLst>
            <pc:docMk/>
            <pc:sldMk cId="2571561803" sldId="298"/>
            <ac:spMk id="44" creationId="{9C9542D5-6CD9-4FF4-B41E-B51A13A68304}"/>
          </ac:spMkLst>
        </pc:spChg>
        <pc:spChg chg="mod">
          <ac:chgData name="Daniel Rico" userId="0a475d9e3b43bc68" providerId="LiveId" clId="{033398EC-C951-4AC8-BF7E-678ADC764D8A}" dt="2020-11-22T19:01:54.044" v="378" actId="6549"/>
          <ac:spMkLst>
            <pc:docMk/>
            <pc:sldMk cId="2571561803" sldId="298"/>
            <ac:spMk id="45" creationId="{979E2B8D-774D-4883-93BC-08956FBBC8CC}"/>
          </ac:spMkLst>
        </pc:spChg>
      </pc:sldChg>
      <pc:sldChg chg="modSp mod">
        <pc:chgData name="Daniel Rico" userId="0a475d9e3b43bc68" providerId="LiveId" clId="{033398EC-C951-4AC8-BF7E-678ADC764D8A}" dt="2020-11-22T19:00:04.825" v="375" actId="20577"/>
        <pc:sldMkLst>
          <pc:docMk/>
          <pc:sldMk cId="2711957844" sldId="303"/>
        </pc:sldMkLst>
        <pc:spChg chg="mod">
          <ac:chgData name="Daniel Rico" userId="0a475d9e3b43bc68" providerId="LiveId" clId="{033398EC-C951-4AC8-BF7E-678ADC764D8A}" dt="2020-11-22T19:00:04.825" v="375" actId="20577"/>
          <ac:spMkLst>
            <pc:docMk/>
            <pc:sldMk cId="2711957844" sldId="303"/>
            <ac:spMk id="4" creationId="{30602BBA-EFEA-4BA9-A5B8-6E13F77F3784}"/>
          </ac:spMkLst>
        </pc:spChg>
        <pc:spChg chg="mod">
          <ac:chgData name="Daniel Rico" userId="0a475d9e3b43bc68" providerId="LiveId" clId="{033398EC-C951-4AC8-BF7E-678ADC764D8A}" dt="2020-11-22T18:26:37.484" v="94" actId="20577"/>
          <ac:spMkLst>
            <pc:docMk/>
            <pc:sldMk cId="2711957844" sldId="303"/>
            <ac:spMk id="26" creationId="{C8E9553D-0363-48A1-9E2B-5ACA15F38024}"/>
          </ac:spMkLst>
        </pc:spChg>
        <pc:spChg chg="mod">
          <ac:chgData name="Daniel Rico" userId="0a475d9e3b43bc68" providerId="LiveId" clId="{033398EC-C951-4AC8-BF7E-678ADC764D8A}" dt="2020-11-22T18:26:46.317" v="96" actId="20577"/>
          <ac:spMkLst>
            <pc:docMk/>
            <pc:sldMk cId="2711957844" sldId="303"/>
            <ac:spMk id="27" creationId="{4745CF76-608C-47FA-8CAA-C3C293410412}"/>
          </ac:spMkLst>
        </pc:spChg>
        <pc:spChg chg="mod">
          <ac:chgData name="Daniel Rico" userId="0a475d9e3b43bc68" providerId="LiveId" clId="{033398EC-C951-4AC8-BF7E-678ADC764D8A}" dt="2020-11-22T18:27:35.948" v="101" actId="20577"/>
          <ac:spMkLst>
            <pc:docMk/>
            <pc:sldMk cId="2711957844" sldId="303"/>
            <ac:spMk id="34" creationId="{0AA6BD9A-EAD7-4889-9DCC-1FE6C9484E2E}"/>
          </ac:spMkLst>
        </pc:spChg>
        <pc:spChg chg="mod">
          <ac:chgData name="Daniel Rico" userId="0a475d9e3b43bc68" providerId="LiveId" clId="{033398EC-C951-4AC8-BF7E-678ADC764D8A}" dt="2020-11-22T18:27:46.668" v="102" actId="20577"/>
          <ac:spMkLst>
            <pc:docMk/>
            <pc:sldMk cId="2711957844" sldId="303"/>
            <ac:spMk id="38" creationId="{DF453B44-3B58-4D1F-AF54-C03C204B3535}"/>
          </ac:spMkLst>
        </pc:spChg>
        <pc:spChg chg="mod">
          <ac:chgData name="Daniel Rico" userId="0a475d9e3b43bc68" providerId="LiveId" clId="{033398EC-C951-4AC8-BF7E-678ADC764D8A}" dt="2020-11-22T18:27:30.823" v="99" actId="1076"/>
          <ac:spMkLst>
            <pc:docMk/>
            <pc:sldMk cId="2711957844" sldId="303"/>
            <ac:spMk id="39" creationId="{A2595D00-5B45-4B6A-B4F6-8B5846FC4877}"/>
          </ac:spMkLst>
        </pc:spChg>
      </pc:sldChg>
      <pc:sldChg chg="modSp mod">
        <pc:chgData name="Daniel Rico" userId="0a475d9e3b43bc68" providerId="LiveId" clId="{033398EC-C951-4AC8-BF7E-678ADC764D8A}" dt="2020-11-22T19:40:58.492" v="727" actId="1035"/>
        <pc:sldMkLst>
          <pc:docMk/>
          <pc:sldMk cId="558716251" sldId="304"/>
        </pc:sldMkLst>
        <pc:spChg chg="mod">
          <ac:chgData name="Daniel Rico" userId="0a475d9e3b43bc68" providerId="LiveId" clId="{033398EC-C951-4AC8-BF7E-678ADC764D8A}" dt="2020-11-22T19:39:49.031" v="667" actId="20577"/>
          <ac:spMkLst>
            <pc:docMk/>
            <pc:sldMk cId="558716251" sldId="304"/>
            <ac:spMk id="5" creationId="{9C1F7266-8B41-43E4-B13D-C300C95615DA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6" creationId="{C0774469-0098-41CC-A880-FAE3C7F7ADE0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7" creationId="{B0C5425D-4821-46E2-B1B8-D6313DE09E77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8" creationId="{A4A7FF81-6B54-4B4E-832B-0A1627D8E219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9" creationId="{6AF4969F-F353-44D1-AFD5-923834BE562E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10" creationId="{A6DF650C-9249-479F-BACD-D6D085FC7011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12" creationId="{3F99A236-E367-4503-AFED-292C509CF1BB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30" creationId="{817CB9B2-3C07-4F1A-BDA3-C26B51BFA91D}"/>
          </ac:spMkLst>
        </pc:spChg>
        <pc:spChg chg="mod">
          <ac:chgData name="Daniel Rico" userId="0a475d9e3b43bc68" providerId="LiveId" clId="{033398EC-C951-4AC8-BF7E-678ADC764D8A}" dt="2020-11-22T19:39:40.259" v="663" actId="1038"/>
          <ac:spMkLst>
            <pc:docMk/>
            <pc:sldMk cId="558716251" sldId="304"/>
            <ac:spMk id="31" creationId="{BE00EE17-353F-49C3-BB28-51913CD6AF89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2" creationId="{D3C044A2-A8DF-463D-A759-B4E76881EE51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3" creationId="{2466AD63-602D-48AA-9FAC-FB7BDA69F088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4" creationId="{083E53DA-1FA5-4C62-99F5-C2BA27DB862C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5" creationId="{1EF78EC8-0D57-4EA7-8E85-06444F562F93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6" creationId="{AE434E49-CC91-455D-90BB-FF74A6DDF330}"/>
          </ac:spMkLst>
        </pc:spChg>
        <pc:spChg chg="mod">
          <ac:chgData name="Daniel Rico" userId="0a475d9e3b43bc68" providerId="LiveId" clId="{033398EC-C951-4AC8-BF7E-678ADC764D8A}" dt="2020-11-22T19:40:58.492" v="727" actId="1035"/>
          <ac:spMkLst>
            <pc:docMk/>
            <pc:sldMk cId="558716251" sldId="304"/>
            <ac:spMk id="37" creationId="{15C53627-8EEE-42F7-AB97-AE0361AD7DD0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8" creationId="{2896CDEE-E783-493B-9278-A0BA1513596B}"/>
          </ac:spMkLst>
        </pc:spChg>
        <pc:spChg chg="mod">
          <ac:chgData name="Daniel Rico" userId="0a475d9e3b43bc68" providerId="LiveId" clId="{033398EC-C951-4AC8-BF7E-678ADC764D8A}" dt="2020-11-22T19:40:49.143" v="723" actId="1038"/>
          <ac:spMkLst>
            <pc:docMk/>
            <pc:sldMk cId="558716251" sldId="304"/>
            <ac:spMk id="39" creationId="{C950D60C-82FB-4804-9482-9B2B9E6F9260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0" creationId="{2E53B164-BF60-4821-8227-5CF84F88AC54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1" creationId="{B2ABD43D-DAD9-4866-ACE7-8FD3FE811184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2" creationId="{AE9E0124-5F9B-42E2-BFCC-A529EB1AB1DE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3" creationId="{91E6A7A3-4D06-4C23-A2E8-8CD23E2FD6C3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4" creationId="{C97B7C65-E388-494E-879E-AE614D651F4E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5" creationId="{340E7A12-DB0E-41C0-8027-8AFA92C3600B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6" creationId="{C4D7C730-62D8-4A06-A0EC-3C67AC52CF47}"/>
          </ac:spMkLst>
        </pc:spChg>
        <pc:spChg chg="mod">
          <ac:chgData name="Daniel Rico" userId="0a475d9e3b43bc68" providerId="LiveId" clId="{033398EC-C951-4AC8-BF7E-678ADC764D8A}" dt="2020-11-22T19:40:38.915" v="713" actId="1035"/>
          <ac:spMkLst>
            <pc:docMk/>
            <pc:sldMk cId="558716251" sldId="304"/>
            <ac:spMk id="47" creationId="{C0743D44-3F3F-4092-B5B3-A00EFDF76331}"/>
          </ac:spMkLst>
        </pc:spChg>
        <pc:graphicFrameChg chg="mod">
          <ac:chgData name="Daniel Rico" userId="0a475d9e3b43bc68" providerId="LiveId" clId="{033398EC-C951-4AC8-BF7E-678ADC764D8A}" dt="2020-11-22T19:40:29.192" v="691" actId="14100"/>
          <ac:graphicFrameMkLst>
            <pc:docMk/>
            <pc:sldMk cId="558716251" sldId="304"/>
            <ac:graphicFrameMk id="3" creationId="{FCE0AD9A-DFAB-4B70-9BEE-DF4FAD2F0E82}"/>
          </ac:graphicFrameMkLst>
        </pc:graphicFrameChg>
        <pc:graphicFrameChg chg="mod">
          <ac:chgData name="Daniel Rico" userId="0a475d9e3b43bc68" providerId="LiveId" clId="{033398EC-C951-4AC8-BF7E-678ADC764D8A}" dt="2020-11-22T19:40:38.915" v="713" actId="1035"/>
          <ac:graphicFrameMkLst>
            <pc:docMk/>
            <pc:sldMk cId="558716251" sldId="304"/>
            <ac:graphicFrameMk id="4" creationId="{A4262E9F-FDA3-44B5-AA8B-D4A1AB7C4FCF}"/>
          </ac:graphicFrameMkLst>
        </pc:graphicFrameChg>
      </pc:sldChg>
      <pc:sldChg chg="modSp mod">
        <pc:chgData name="Daniel Rico" userId="0a475d9e3b43bc68" providerId="LiveId" clId="{033398EC-C951-4AC8-BF7E-678ADC764D8A}" dt="2020-11-22T19:03:22.075" v="381"/>
        <pc:sldMkLst>
          <pc:docMk/>
          <pc:sldMk cId="3010957323" sldId="306"/>
        </pc:sldMkLst>
        <pc:spChg chg="mod">
          <ac:chgData name="Daniel Rico" userId="0a475d9e3b43bc68" providerId="LiveId" clId="{033398EC-C951-4AC8-BF7E-678ADC764D8A}" dt="2020-11-22T19:03:22.075" v="381"/>
          <ac:spMkLst>
            <pc:docMk/>
            <pc:sldMk cId="3010957323" sldId="306"/>
            <ac:spMk id="533" creationId="{B7CA3355-618D-4360-B015-801313E7F1E1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itanetapp4\usuarios$\mardiaan\DOCUMENTOS\24072020\RRHH-MARIA%20JESUS\paper\graficos\alpha-tocophero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Hoja1!$H$29:$H$32</c:f>
              <c:strCache>
                <c:ptCount val="4"/>
                <c:pt idx="0">
                  <c:v>WG</c:v>
                </c:pt>
                <c:pt idx="1">
                  <c:v>WB</c:v>
                </c:pt>
                <c:pt idx="2">
                  <c:v>OG</c:v>
                </c:pt>
                <c:pt idx="3">
                  <c:v>OB</c:v>
                </c:pt>
              </c:strCache>
            </c:strRef>
          </c:cat>
          <c:val>
            <c:numRef>
              <c:f>Hoja1!$J$29:$J$32</c:f>
              <c:numCache>
                <c:formatCode>General</c:formatCode>
                <c:ptCount val="4"/>
                <c:pt idx="0">
                  <c:v>1260.1294528143958</c:v>
                </c:pt>
                <c:pt idx="1">
                  <c:v>619.7916084664588</c:v>
                </c:pt>
                <c:pt idx="2">
                  <c:v>1190.4570687283667</c:v>
                </c:pt>
                <c:pt idx="3">
                  <c:v>710.717919718636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58-45D0-89EA-5F63EB9CFF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5519375"/>
        <c:axId val="535775807"/>
      </c:barChart>
      <c:catAx>
        <c:axId val="5255193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35775807"/>
        <c:crosses val="autoZero"/>
        <c:auto val="1"/>
        <c:lblAlgn val="ctr"/>
        <c:lblOffset val="100"/>
        <c:noMultiLvlLbl val="0"/>
      </c:catAx>
      <c:valAx>
        <c:axId val="53577580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Arial" panose="020B0604020202020204" pitchFamily="34" charset="0"/>
                  </a:defRPr>
                </a:pPr>
                <a:r>
                  <a:rPr lang="el-GR" sz="1000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α-</a:t>
                </a:r>
                <a:r>
                  <a:rPr lang="es-ES" sz="1000" dirty="0" err="1">
                    <a:latin typeface="Palatino Linotype" panose="02040502050505030304" pitchFamily="18" charset="0"/>
                    <a:cs typeface="Arial" panose="020B0604020202020204" pitchFamily="34" charset="0"/>
                  </a:rPr>
                  <a:t>Tocopherol</a:t>
                </a:r>
                <a:r>
                  <a:rPr lang="es-ES" sz="1000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 (</a:t>
                </a:r>
                <a:r>
                  <a:rPr lang="es-ES" sz="1000" b="0" i="0" u="none" strike="noStrike" baseline="0" dirty="0">
                    <a:effectLst/>
                    <a:latin typeface="Palatino Linotype" panose="02040502050505030304" pitchFamily="18" charset="0"/>
                  </a:rPr>
                  <a:t>µg </a:t>
                </a:r>
                <a:r>
                  <a:rPr lang="es-ES" sz="1000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100 g </a:t>
                </a:r>
                <a:r>
                  <a:rPr lang="es-ES" sz="1000" baseline="30000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-1</a:t>
                </a:r>
                <a:r>
                  <a:rPr lang="es-ES" sz="1000" baseline="0" dirty="0">
                    <a:latin typeface="Palatino Linotype" panose="02040502050505030304" pitchFamily="18" charset="0"/>
                    <a:cs typeface="Arial" panose="020B0604020202020204" pitchFamily="34" charset="0"/>
                  </a:rPr>
                  <a:t>)</a:t>
                </a:r>
                <a:endParaRPr lang="es-ES" sz="1000" baseline="30000" dirty="0">
                  <a:latin typeface="Palatino Linotype" panose="02040502050505030304" pitchFamily="18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25519375"/>
        <c:crosses val="autoZero"/>
        <c:crossBetween val="between"/>
      </c:valAx>
      <c:spPr>
        <a:noFill/>
        <a:ln>
          <a:solidFill>
            <a:schemeClr val="bg1">
              <a:lumMod val="6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00BAAF9-4B03-40BD-A674-E7259F0F2A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0F93FC7-79FD-4438-BED3-9FEB62F4E7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6DAD737-AC8E-4AD4-9B85-E364F9A53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5E7D14-C8F8-4AE1-93FE-2990ED2B3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B56DF71-F8AE-4BBA-99E2-BDEB028A5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6087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B2E747-5929-4157-B65E-D4A0176986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5D287B5-D4BD-4774-88D4-14D35A2B68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0484DB5-3C75-4E52-A274-41421A4C9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184CE59-1B7E-4778-BC93-44107EAD8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B4C792-F36E-40FA-9CAD-359AAF760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008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0D99BF4-DB15-4D36-9C36-E2FB1C6F56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6686F23-EECF-47F0-9AAF-FDBE72AE84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68A48F5-3380-4FD3-956B-5B18C4C4C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71A0A99-EF67-4389-BFFC-90B5F7875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EA2B368-94FB-4904-85D4-E4A3A0E76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1334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4640A6-9597-46E9-8FE4-8A85E05837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F9D461E-4B89-497E-B673-44A0320159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FC5C610-B9E9-4793-87DD-2DB8AF3FA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A734A67-A62C-48F9-878C-8AFCE513C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454E4ED-397B-4999-A51A-47E7BBDD8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4627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A7E039-C5D6-4820-A010-7EF0C784FE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3297664-D2A4-4DF2-B664-E3C0F61AB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9D11787-F37A-4558-8E3E-17BB25B7F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F1D2B4E-DAD9-4EFE-B6A3-1A626554A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A8293B9-0625-4F1A-9E9B-50437A74A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7562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403E5D-923C-4C8B-A81C-EDB3765E44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71B73C1-F2C6-461E-9C2B-9A93E9E7D4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C9CAE19-A13C-4C44-86AF-E93844C657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188752A-0AB4-485A-B61C-649463DB1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C3648B2-8B7C-4375-A7A0-AE25FAD52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FD01948-2928-44B7-8CDA-BF9CC67E3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7101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CDE141-B65B-4160-81E8-A8FEC3279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1D4A068-52CA-4CCE-A794-937C3771E6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F2BCE08-AB10-4E7E-84C9-0FF422C9FF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049EC6D-EC1E-493E-B9F0-545C0FDE96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08C4888-18D2-4EDE-AF01-DA5B9C1460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E73ADDD-FC96-46DD-8C68-AFD3266D9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17AAF18-3C30-4E82-91B4-D1117DDD9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3583F87-AC73-4271-9B98-1F39BEC9D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7520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247EE1-CBAC-4D20-B249-C304033556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6039949-67E0-4C61-87E6-0AD87DA7C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5B090529-AD1F-40F4-9CE8-CB6AF7617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AAC3E66-829B-4A32-A583-5A073413A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5729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BA099FD-D2DA-43E8-AC05-F367B82E7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5EE28C4-5FC5-4378-802A-D88AAB1F3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BF9661C-E0DB-4C1E-AB8F-A019A61AB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1025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E145B9-3FC7-45A2-8376-E570B4F719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F28A30D-073B-41F6-8E81-DC0E677FE8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D35808D-A314-46B3-8F5F-9BDE3CF3D3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89C7505-F2C6-42E5-A06F-1C5201766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FD85008-EF19-4F7A-A9E1-4C3F444CD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E305AE0-A8CA-4E77-A906-25F89F92D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3216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DABF16-D1E9-4B76-8EC1-62B5B92A3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B31570B-D333-4439-BA27-9D529293A0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5109A63-4456-456A-A6A5-4A913F8556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035DDE2-DE7C-4860-AB0A-16E02F222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673F2CA-0377-485A-A6B2-BBF936F7D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1B82446-8D12-4390-8495-90E4537BF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8436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30050F0-6996-4F80-9258-0CC7E6033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28F8B94-6E40-4DC5-A629-95FD7C8BC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99462AC-717B-4BAB-B153-FF5A9ABEE4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66970-6189-4322-8C09-4C2CC622DF9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D06FD7C-B3AB-419C-897A-D299F91B6A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B8035DF-EA2F-428D-AA57-37A27E5A4B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16256-5FC4-4842-9958-FC35D72AB5E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713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>
            <a:extLst>
              <a:ext uri="{FF2B5EF4-FFF2-40B4-BE49-F238E27FC236}">
                <a16:creationId xmlns:a16="http://schemas.microsoft.com/office/drawing/2014/main" id="{98ABF806-7521-4D17-98FA-D2F29F5AC97C}"/>
              </a:ext>
            </a:extLst>
          </p:cNvPr>
          <p:cNvSpPr/>
          <p:nvPr/>
        </p:nvSpPr>
        <p:spPr>
          <a:xfrm>
            <a:off x="651028" y="117603"/>
            <a:ext cx="1080116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sz="1000" b="1" dirty="0">
                <a:latin typeface="Palatino Linotype" panose="02040502050505030304" pitchFamily="18" charset="0"/>
                <a:cs typeface="Arial" pitchFamily="34" charset="0"/>
              </a:rPr>
              <a:t>Table S1.</a:t>
            </a:r>
            <a:r>
              <a:rPr lang="en-US" sz="1000" dirty="0">
                <a:latin typeface="Palatino Linotype" panose="02040502050505030304" pitchFamily="18" charset="0"/>
                <a:cs typeface="Arial" pitchFamily="34" charset="0"/>
              </a:rPr>
              <a:t> Correlation analysis </a:t>
            </a:r>
            <a:r>
              <a:rPr lang="en-US" altLang="es-ES" sz="1000" dirty="0">
                <a:latin typeface="Palatino Linotype" panose="02040502050505030304" pitchFamily="18" charset="0"/>
                <a:cs typeface="Arial" pitchFamily="34" charset="0"/>
              </a:rPr>
              <a:t>of antioxidant parameters (DPPH, ORAC, ABTS , FRAP and RACI).</a:t>
            </a:r>
            <a:r>
              <a:rPr lang="en-IE" sz="1000" b="1" dirty="0">
                <a:latin typeface="Palatino Linotype" panose="02040502050505030304" pitchFamily="18" charset="0"/>
                <a:cs typeface="Arial" pitchFamily="34" charset="0"/>
              </a:rPr>
              <a:t> </a:t>
            </a:r>
            <a:endParaRPr lang="es-ES" sz="10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10" name="Tabla 9">
            <a:extLst>
              <a:ext uri="{FF2B5EF4-FFF2-40B4-BE49-F238E27FC236}">
                <a16:creationId xmlns:a16="http://schemas.microsoft.com/office/drawing/2014/main" id="{BF6F9296-812C-4FDC-ACFF-459A61C3AE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524194"/>
              </p:ext>
            </p:extLst>
          </p:nvPr>
        </p:nvGraphicFramePr>
        <p:xfrm>
          <a:off x="3293616" y="1438183"/>
          <a:ext cx="5770485" cy="2627793"/>
        </p:xfrm>
        <a:graphic>
          <a:graphicData uri="http://schemas.openxmlformats.org/drawingml/2006/table">
            <a:tbl>
              <a:tblPr/>
              <a:tblGrid>
                <a:gridCol w="824355">
                  <a:extLst>
                    <a:ext uri="{9D8B030D-6E8A-4147-A177-3AD203B41FA5}">
                      <a16:colId xmlns:a16="http://schemas.microsoft.com/office/drawing/2014/main" val="3798573151"/>
                    </a:ext>
                  </a:extLst>
                </a:gridCol>
                <a:gridCol w="824355">
                  <a:extLst>
                    <a:ext uri="{9D8B030D-6E8A-4147-A177-3AD203B41FA5}">
                      <a16:colId xmlns:a16="http://schemas.microsoft.com/office/drawing/2014/main" val="1291852557"/>
                    </a:ext>
                  </a:extLst>
                </a:gridCol>
                <a:gridCol w="824355">
                  <a:extLst>
                    <a:ext uri="{9D8B030D-6E8A-4147-A177-3AD203B41FA5}">
                      <a16:colId xmlns:a16="http://schemas.microsoft.com/office/drawing/2014/main" val="3390604221"/>
                    </a:ext>
                  </a:extLst>
                </a:gridCol>
                <a:gridCol w="824355">
                  <a:extLst>
                    <a:ext uri="{9D8B030D-6E8A-4147-A177-3AD203B41FA5}">
                      <a16:colId xmlns:a16="http://schemas.microsoft.com/office/drawing/2014/main" val="1090216805"/>
                    </a:ext>
                  </a:extLst>
                </a:gridCol>
                <a:gridCol w="824355">
                  <a:extLst>
                    <a:ext uri="{9D8B030D-6E8A-4147-A177-3AD203B41FA5}">
                      <a16:colId xmlns:a16="http://schemas.microsoft.com/office/drawing/2014/main" val="2240771122"/>
                    </a:ext>
                  </a:extLst>
                </a:gridCol>
                <a:gridCol w="824355">
                  <a:extLst>
                    <a:ext uri="{9D8B030D-6E8A-4147-A177-3AD203B41FA5}">
                      <a16:colId xmlns:a16="http://schemas.microsoft.com/office/drawing/2014/main" val="1439841263"/>
                    </a:ext>
                  </a:extLst>
                </a:gridCol>
                <a:gridCol w="824355">
                  <a:extLst>
                    <a:ext uri="{9D8B030D-6E8A-4147-A177-3AD203B41FA5}">
                      <a16:colId xmlns:a16="http://schemas.microsoft.com/office/drawing/2014/main" val="2982958877"/>
                    </a:ext>
                  </a:extLst>
                </a:gridCol>
              </a:tblGrid>
              <a:tr h="375399"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P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R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PP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RA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A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5510505"/>
                  </a:ext>
                </a:extLst>
              </a:tr>
              <a:tr h="375399"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P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3877258"/>
                  </a:ext>
                </a:extLst>
              </a:tr>
              <a:tr h="375399"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R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8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4382625"/>
                  </a:ext>
                </a:extLst>
              </a:tr>
              <a:tr h="375399"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PP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8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9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6395520"/>
                  </a:ext>
                </a:extLst>
              </a:tr>
              <a:tr h="375399"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4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7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8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10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640523"/>
                  </a:ext>
                </a:extLst>
              </a:tr>
              <a:tr h="375399"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RA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2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5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7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3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5934679"/>
                  </a:ext>
                </a:extLst>
              </a:tr>
              <a:tr h="375399"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A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7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5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5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3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5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31963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29397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id="{B8CAFF12-8B64-4E9E-827E-3F286C5937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4725316"/>
              </p:ext>
            </p:extLst>
          </p:nvPr>
        </p:nvGraphicFramePr>
        <p:xfrm>
          <a:off x="1650065" y="1031501"/>
          <a:ext cx="8891869" cy="47949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7 Rectángulo">
            <a:extLst>
              <a:ext uri="{FF2B5EF4-FFF2-40B4-BE49-F238E27FC236}">
                <a16:creationId xmlns:a16="http://schemas.microsoft.com/office/drawing/2014/main" id="{4E06528A-46EC-46FB-8959-6FFAAD5997FD}"/>
              </a:ext>
            </a:extLst>
          </p:cNvPr>
          <p:cNvSpPr/>
          <p:nvPr/>
        </p:nvSpPr>
        <p:spPr>
          <a:xfrm>
            <a:off x="415150" y="381504"/>
            <a:ext cx="1136169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Palatino Linotype" panose="02040502050505030304" pitchFamily="18" charset="0"/>
                <a:cs typeface="Arial" pitchFamily="34" charset="0"/>
              </a:rPr>
              <a:t>Figure S1. </a:t>
            </a:r>
            <a:r>
              <a:rPr lang="el-GR" altLang="es-ES" sz="1000" dirty="0">
                <a:latin typeface="Palatino Linotype" panose="02040502050505030304" pitchFamily="18" charset="0"/>
                <a:ea typeface="Calibri" panose="020F0502020204030204" pitchFamily="34" charset="0"/>
                <a:cs typeface="Arial" pitchFamily="34" charset="0"/>
              </a:rPr>
              <a:t>α-</a:t>
            </a:r>
            <a:r>
              <a:rPr lang="en-GB" altLang="es-ES" sz="1000" dirty="0">
                <a:latin typeface="Palatino Linotype" panose="02040502050505030304" pitchFamily="18" charset="0"/>
                <a:ea typeface="Calibri" panose="020F0502020204030204" pitchFamily="34" charset="0"/>
                <a:cs typeface="Arial" pitchFamily="34" charset="0"/>
              </a:rPr>
              <a:t>Tocopherol  </a:t>
            </a:r>
            <a:r>
              <a:rPr lang="en-US" altLang="es-ES" sz="1000" dirty="0">
                <a:latin typeface="Palatino Linotype" panose="02040502050505030304" pitchFamily="18" charset="0"/>
                <a:ea typeface="Calibri" panose="020F0502020204030204" pitchFamily="34" charset="0"/>
                <a:cs typeface="Arial" pitchFamily="34" charset="0"/>
              </a:rPr>
              <a:t>content of wheat grain (WG), oat grain (OG) and their brans weight bran (WB) and oat bran (OB). Results were expressed </a:t>
            </a:r>
            <a:r>
              <a:rPr lang="es-ES" sz="1000" dirty="0"/>
              <a:t>µg 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100 g </a:t>
            </a:r>
            <a:r>
              <a:rPr lang="es-E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aseline="30000" dirty="0">
                <a:latin typeface="Palatino Linotype" panose="02040502050505030304" pitchFamily="18" charset="0"/>
                <a:cs typeface="Arial" pitchFamily="34" charset="0"/>
              </a:rPr>
              <a:t>  </a:t>
            </a:r>
            <a:r>
              <a:rPr lang="en-US" sz="1000" dirty="0">
                <a:latin typeface="Palatino Linotype" panose="02040502050505030304" pitchFamily="18" charset="0"/>
                <a:cs typeface="Arial" pitchFamily="34" charset="0"/>
              </a:rPr>
              <a:t>of lipid. </a:t>
            </a:r>
            <a:r>
              <a:rPr lang="en-US" altLang="es-ES" sz="1000" dirty="0">
                <a:latin typeface="Palatino Linotype" panose="02040502050505030304" pitchFamily="18" charset="0"/>
                <a:cs typeface="Arial" pitchFamily="34" charset="0"/>
              </a:rPr>
              <a:t>Columns </a:t>
            </a:r>
            <a:r>
              <a:rPr lang="en-US" altLang="es-ES" sz="1000" dirty="0">
                <a:latin typeface="Palatino Linotype" panose="02040502050505030304" pitchFamily="18" charset="0"/>
                <a:ea typeface="Calibri" panose="020F0502020204030204" pitchFamily="34" charset="0"/>
                <a:cs typeface="Arial" pitchFamily="34" charset="0"/>
              </a:rPr>
              <a:t>with different small letters show significant differences between samples (p &lt; 0.05).</a:t>
            </a:r>
            <a:endParaRPr lang="es-ES" altLang="es-ES" sz="1000" dirty="0">
              <a:latin typeface="Palatino Linotype" panose="02040502050505030304" pitchFamily="18" charset="0"/>
              <a:ea typeface="Calibri" panose="020F050202020403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3541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9C6BE5AA-3CB6-4675-881E-B165AEDDAF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0259" y="740556"/>
            <a:ext cx="10471481" cy="5908673"/>
          </a:xfrm>
          <a:prstGeom prst="rect">
            <a:avLst/>
          </a:prstGeom>
        </p:spPr>
      </p:pic>
      <p:sp>
        <p:nvSpPr>
          <p:cNvPr id="148" name="7 Rectángulo">
            <a:extLst>
              <a:ext uri="{FF2B5EF4-FFF2-40B4-BE49-F238E27FC236}">
                <a16:creationId xmlns:a16="http://schemas.microsoft.com/office/drawing/2014/main" id="{79E4A8A8-E266-4EC0-A419-9844D5ED7B02}"/>
              </a:ext>
            </a:extLst>
          </p:cNvPr>
          <p:cNvSpPr/>
          <p:nvPr/>
        </p:nvSpPr>
        <p:spPr>
          <a:xfrm>
            <a:off x="415150" y="208771"/>
            <a:ext cx="11361699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spcAft>
                <a:spcPts val="0"/>
              </a:spcAft>
            </a:pPr>
            <a:r>
              <a:rPr lang="en-GB" sz="1000" b="1" dirty="0">
                <a:latin typeface="Palatino Linotype" panose="02040502050505030304" pitchFamily="18" charset="0"/>
                <a:cs typeface="Arial" pitchFamily="34" charset="0"/>
              </a:rPr>
              <a:t>Figure S2. </a:t>
            </a:r>
            <a:r>
              <a:rPr lang="en-IE" sz="1000" dirty="0">
                <a:latin typeface="Calibri" panose="020F0502020204030204" pitchFamily="34" charset="0"/>
                <a:ea typeface="Calibri" panose="020F0502020204030204" pitchFamily="34" charset="0"/>
              </a:rPr>
              <a:t>Representative examples of the chromatographic profile of soluble and insoluble extracts. A)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Wholegrain wheat soluble extract at 290 nm; B) Wholegrain oat soluble extract at 290 nm. </a:t>
            </a:r>
            <a:r>
              <a:rPr lang="es-ES" sz="1000" dirty="0">
                <a:latin typeface="Calibri" panose="020F0502020204030204" pitchFamily="34" charset="0"/>
                <a:ea typeface="Calibri" panose="020F0502020204030204" pitchFamily="34" charset="0"/>
              </a:rPr>
              <a:t>C) </a:t>
            </a:r>
            <a:r>
              <a:rPr lang="es-E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Wholegrain</a:t>
            </a:r>
            <a:r>
              <a:rPr lang="es-ES" sz="10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s-E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wheat</a:t>
            </a:r>
            <a:r>
              <a:rPr lang="es-ES" sz="1000" dirty="0">
                <a:latin typeface="Calibri" panose="020F0502020204030204" pitchFamily="34" charset="0"/>
                <a:ea typeface="Calibri" panose="020F0502020204030204" pitchFamily="34" charset="0"/>
              </a:rPr>
              <a:t> insoluble </a:t>
            </a:r>
            <a:r>
              <a:rPr lang="es-ES" sz="1000" dirty="0" err="1">
                <a:latin typeface="Calibri" panose="020F0502020204030204" pitchFamily="34" charset="0"/>
                <a:ea typeface="Calibri" panose="020F0502020204030204" pitchFamily="34" charset="0"/>
              </a:rPr>
              <a:t>extract</a:t>
            </a:r>
            <a:r>
              <a:rPr lang="es-ES" sz="1000" dirty="0">
                <a:latin typeface="Calibri" panose="020F0502020204030204" pitchFamily="34" charset="0"/>
                <a:ea typeface="Calibri" panose="020F0502020204030204" pitchFamily="34" charset="0"/>
              </a:rPr>
              <a:t> at 320 nm.</a:t>
            </a:r>
          </a:p>
          <a:p>
            <a:pPr algn="just"/>
            <a:endParaRPr lang="es-ES" altLang="es-ES" sz="1000" dirty="0">
              <a:latin typeface="Palatino Linotype" panose="02040502050505030304" pitchFamily="18" charset="0"/>
              <a:ea typeface="Calibri" panose="020F050202020403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43296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18</TotalTime>
  <Words>172</Words>
  <Application>Microsoft Office PowerPoint</Application>
  <PresentationFormat>Widescreen</PresentationFormat>
  <Paragraphs>4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Jesús García Casas</dc:creator>
  <cp:lastModifiedBy>MDPI-74</cp:lastModifiedBy>
  <cp:revision>503</cp:revision>
  <dcterms:created xsi:type="dcterms:W3CDTF">2020-03-27T08:34:35Z</dcterms:created>
  <dcterms:modified xsi:type="dcterms:W3CDTF">2021-01-06T22:41:38Z</dcterms:modified>
</cp:coreProperties>
</file>